
<file path=[Content_Types].xml><?xml version="1.0" encoding="utf-8"?>
<Types xmlns="http://schemas.openxmlformats.org/package/2006/content-types">
  <Default Extension="xml" ContentType="application/xml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7"/>
  </p:notesMasterIdLst>
  <p:sldIdLst>
    <p:sldId id="274" r:id="rId2"/>
    <p:sldId id="275" r:id="rId3"/>
    <p:sldId id="276" r:id="rId4"/>
    <p:sldId id="265" r:id="rId5"/>
    <p:sldId id="269" r:id="rId6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23" roundtripDataSignature="AMtx7mhZA7kS9+YVHYuq6N+z8vAweeAzm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8C7862BF-6F77-42FA-9AA2-2A108357260E}">
  <a:tblStyle styleId="{8C7862BF-6F77-42FA-9AA2-2A108357260E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left>
          <a:right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right>
          <a:top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  <a:bottom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  <a:insideH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H>
          <a:insideV>
            <a:ln w="127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tcBdr/>
        <a:fill>
          <a:solidFill>
            <a:srgbClr val="CDD4EA"/>
          </a:solidFill>
        </a:fill>
      </a:tcStyle>
    </a:band1H>
    <a:band2H>
      <a:tcTxStyle/>
      <a:tcStyle>
        <a:tcBdr/>
      </a:tcStyle>
    </a:band2H>
    <a:band1V>
      <a:tcTxStyle/>
      <a:tcStyle>
        <a:tcBdr/>
        <a:fill>
          <a:solidFill>
            <a:srgbClr val="CDD4EA"/>
          </a:solidFill>
        </a:fill>
      </a:tcStyle>
    </a:band1V>
    <a:band2V>
      <a:tcTxStyle/>
      <a:tcStyle>
        <a:tcBdr/>
      </a:tcStyle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top>
        </a:tcBdr>
        <a:fill>
          <a:solidFill>
            <a:schemeClr val="accent1"/>
          </a:solidFill>
        </a:fill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w="38100" cap="flat" cmpd="sng">
              <a:solidFill>
                <a:schemeClr val="lt1"/>
              </a:solidFill>
              <a:prstDash val="solid"/>
              <a:round/>
              <a:headEnd type="none" w="sm" len="sm"/>
              <a:tailEnd type="none" w="sm" len="sm"/>
            </a:ln>
          </a:bottom>
        </a:tcBdr>
        <a:fill>
          <a:solidFill>
            <a:schemeClr val="accent1"/>
          </a:solidFill>
        </a:fill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64"/>
    <p:restoredTop sz="95851"/>
  </p:normalViewPr>
  <p:slideViewPr>
    <p:cSldViewPr snapToGrid="0" snapToObjects="1">
      <p:cViewPr>
        <p:scale>
          <a:sx n="160" d="100"/>
          <a:sy n="160" d="100"/>
        </p:scale>
        <p:origin x="2944" y="-12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23" Type="http://customschemas.google.com/relationships/presentationmetadata" Target="metadata"/><Relationship Id="rId24" Type="http://schemas.openxmlformats.org/officeDocument/2006/relationships/presProps" Target="presProps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25" Type="http://schemas.openxmlformats.org/officeDocument/2006/relationships/viewProps" Target="viewProps.xml"/><Relationship Id="rId2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" name="Google Shape;135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136" name="Google Shape;13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205476066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3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9" name="Google Shape;369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dirty="0"/>
          </a:p>
        </p:txBody>
      </p:sp>
      <p:sp>
        <p:nvSpPr>
          <p:cNvPr id="370" name="Google Shape;370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33196452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空白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竖排标题与文本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2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2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2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2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2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幻灯片" type="title">
  <p:cSld name="TITLE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19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19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8" name="Google Shape;28;p1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节标题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2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2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2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2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2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两栏内容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2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2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2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2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2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较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2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2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7" name="Google Shape;47;p2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2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9" name="Google Shape;49;p2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2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2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仅标题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23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2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内容与标题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2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2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图片与标题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2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2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None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None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2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2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2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2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和竖排文字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2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2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2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2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2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Relationship Id="rId11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061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4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4" Type="http://schemas.openxmlformats.org/officeDocument/2006/relationships/image" Target="../media/image11.emf"/><Relationship Id="rId5" Type="http://schemas.openxmlformats.org/officeDocument/2006/relationships/image" Target="../media/image12.emf"/><Relationship Id="rId6" Type="http://schemas.openxmlformats.org/officeDocument/2006/relationships/image" Target="../media/image13.emf"/><Relationship Id="rId7" Type="http://schemas.openxmlformats.org/officeDocument/2006/relationships/image" Target="../media/image14.emf"/><Relationship Id="rId8" Type="http://schemas.openxmlformats.org/officeDocument/2006/relationships/image" Target="../media/image15.emf"/><Relationship Id="rId9" Type="http://schemas.openxmlformats.org/officeDocument/2006/relationships/image" Target="../media/image16.emf"/><Relationship Id="rId10" Type="http://schemas.openxmlformats.org/officeDocument/2006/relationships/image" Target="../media/image17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4" Type="http://schemas.openxmlformats.org/officeDocument/2006/relationships/image" Target="../media/image19.png"/><Relationship Id="rId5" Type="http://schemas.openxmlformats.org/officeDocument/2006/relationships/image" Target="../media/image20.png"/><Relationship Id="rId6" Type="http://schemas.openxmlformats.org/officeDocument/2006/relationships/image" Target="../media/image21.png"/><Relationship Id="rId7" Type="http://schemas.openxmlformats.org/officeDocument/2006/relationships/image" Target="../media/image22.png"/><Relationship Id="rId8" Type="http://schemas.openxmlformats.org/officeDocument/2006/relationships/image" Target="../media/image23.emf"/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46E997FE-E911-4942-96DA-F2E3596B6B8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9413" t="18771" r="8439" b="14956"/>
          <a:stretch/>
        </p:blipFill>
        <p:spPr>
          <a:xfrm>
            <a:off x="2024110" y="2055533"/>
            <a:ext cx="3710866" cy="4931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" name="文本框 10">
            <a:extLst>
              <a:ext uri="{FF2B5EF4-FFF2-40B4-BE49-F238E27FC236}">
                <a16:creationId xmlns:a16="http://schemas.microsoft.com/office/drawing/2014/main" xmlns="" id="{14C9AE5C-F28A-3A4B-B55A-5EC536A7A86C}"/>
              </a:ext>
            </a:extLst>
          </p:cNvPr>
          <p:cNvSpPr txBox="1"/>
          <p:nvPr/>
        </p:nvSpPr>
        <p:spPr>
          <a:xfrm rot="16200000">
            <a:off x="1568462" y="1442383"/>
            <a:ext cx="1250719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Parental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9" name="文本框 12">
            <a:extLst>
              <a:ext uri="{FF2B5EF4-FFF2-40B4-BE49-F238E27FC236}">
                <a16:creationId xmlns:a16="http://schemas.microsoft.com/office/drawing/2014/main" xmlns="" id="{ADBB2504-A9A9-214A-9B13-51AA99BE6749}"/>
              </a:ext>
            </a:extLst>
          </p:cNvPr>
          <p:cNvSpPr txBox="1"/>
          <p:nvPr/>
        </p:nvSpPr>
        <p:spPr>
          <a:xfrm rot="16200000">
            <a:off x="2311759" y="1620345"/>
            <a:ext cx="62486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1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0" name="文本框 13">
            <a:extLst>
              <a:ext uri="{FF2B5EF4-FFF2-40B4-BE49-F238E27FC236}">
                <a16:creationId xmlns:a16="http://schemas.microsoft.com/office/drawing/2014/main" xmlns="" id="{F776718D-2077-5047-A2B1-89A6FC8877FC}"/>
              </a:ext>
            </a:extLst>
          </p:cNvPr>
          <p:cNvSpPr txBox="1"/>
          <p:nvPr/>
        </p:nvSpPr>
        <p:spPr>
          <a:xfrm rot="16200000">
            <a:off x="2694467" y="1617045"/>
            <a:ext cx="631464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>
                <a:latin typeface="Calibri" charset="0"/>
                <a:ea typeface="Calibri" charset="0"/>
                <a:cs typeface="Calibri" charset="0"/>
              </a:rPr>
              <a:t>#2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1" name="文本框 14">
            <a:extLst>
              <a:ext uri="{FF2B5EF4-FFF2-40B4-BE49-F238E27FC236}">
                <a16:creationId xmlns:a16="http://schemas.microsoft.com/office/drawing/2014/main" xmlns="" id="{89E54BBE-C089-1F48-BC7F-B324ED0ACC73}"/>
              </a:ext>
            </a:extLst>
          </p:cNvPr>
          <p:cNvSpPr txBox="1"/>
          <p:nvPr/>
        </p:nvSpPr>
        <p:spPr>
          <a:xfrm rot="16200000">
            <a:off x="3166341" y="1622517"/>
            <a:ext cx="56575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1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2" name="文本框 15">
            <a:extLst>
              <a:ext uri="{FF2B5EF4-FFF2-40B4-BE49-F238E27FC236}">
                <a16:creationId xmlns:a16="http://schemas.microsoft.com/office/drawing/2014/main" xmlns="" id="{A80C1BDD-D534-664B-8917-8CD39428CE0C}"/>
              </a:ext>
            </a:extLst>
          </p:cNvPr>
          <p:cNvSpPr txBox="1"/>
          <p:nvPr/>
        </p:nvSpPr>
        <p:spPr>
          <a:xfrm rot="16200000">
            <a:off x="3453550" y="1625820"/>
            <a:ext cx="711552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2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3" name="文本框 16">
            <a:extLst>
              <a:ext uri="{FF2B5EF4-FFF2-40B4-BE49-F238E27FC236}">
                <a16:creationId xmlns:a16="http://schemas.microsoft.com/office/drawing/2014/main" xmlns="" id="{5512A8B2-72F8-E24D-A1E2-157C85A41CF6}"/>
              </a:ext>
            </a:extLst>
          </p:cNvPr>
          <p:cNvSpPr txBox="1"/>
          <p:nvPr/>
        </p:nvSpPr>
        <p:spPr>
          <a:xfrm rot="16200000">
            <a:off x="3917325" y="1632822"/>
            <a:ext cx="527387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3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4" name="文本框 17">
            <a:extLst>
              <a:ext uri="{FF2B5EF4-FFF2-40B4-BE49-F238E27FC236}">
                <a16:creationId xmlns:a16="http://schemas.microsoft.com/office/drawing/2014/main" xmlns="" id="{193827F7-F428-0647-A6B4-207E2C82B7B4}"/>
              </a:ext>
            </a:extLst>
          </p:cNvPr>
          <p:cNvSpPr txBox="1"/>
          <p:nvPr/>
        </p:nvSpPr>
        <p:spPr>
          <a:xfrm rot="16200000">
            <a:off x="4416666" y="1640118"/>
            <a:ext cx="588821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1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5" name="文本框 18">
            <a:extLst>
              <a:ext uri="{FF2B5EF4-FFF2-40B4-BE49-F238E27FC236}">
                <a16:creationId xmlns:a16="http://schemas.microsoft.com/office/drawing/2014/main" xmlns="" id="{C1D3FDDD-626E-5445-AD39-D8E3AA7E1CE3}"/>
              </a:ext>
            </a:extLst>
          </p:cNvPr>
          <p:cNvSpPr txBox="1"/>
          <p:nvPr/>
        </p:nvSpPr>
        <p:spPr>
          <a:xfrm rot="16200000">
            <a:off x="4797659" y="1643551"/>
            <a:ext cx="577932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 dirty="0">
                <a:latin typeface="Calibri" charset="0"/>
                <a:ea typeface="Calibri" charset="0"/>
                <a:cs typeface="Calibri" charset="0"/>
              </a:rPr>
              <a:t>#2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6" name="文本框 19">
            <a:extLst>
              <a:ext uri="{FF2B5EF4-FFF2-40B4-BE49-F238E27FC236}">
                <a16:creationId xmlns:a16="http://schemas.microsoft.com/office/drawing/2014/main" xmlns="" id="{2AA7B555-19C1-A74F-95FD-20007E6128AD}"/>
              </a:ext>
            </a:extLst>
          </p:cNvPr>
          <p:cNvSpPr txBox="1"/>
          <p:nvPr/>
        </p:nvSpPr>
        <p:spPr>
          <a:xfrm rot="16200000">
            <a:off x="5257092" y="1629616"/>
            <a:ext cx="427731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lang="en-US" altLang="zh-CN">
                <a:latin typeface="Calibri" charset="0"/>
                <a:ea typeface="Calibri" charset="0"/>
                <a:cs typeface="Calibri" charset="0"/>
              </a:rPr>
              <a:t>#3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7" name="文本框 21">
            <a:extLst>
              <a:ext uri="{FF2B5EF4-FFF2-40B4-BE49-F238E27FC236}">
                <a16:creationId xmlns:a16="http://schemas.microsoft.com/office/drawing/2014/main" xmlns="" id="{9D633659-B77A-D548-8FFC-E0447E776D91}"/>
              </a:ext>
            </a:extLst>
          </p:cNvPr>
          <p:cNvSpPr txBox="1"/>
          <p:nvPr/>
        </p:nvSpPr>
        <p:spPr>
          <a:xfrm>
            <a:off x="1348670" y="2113001"/>
            <a:ext cx="57227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PEAK1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18" name="文本框 23">
            <a:extLst>
              <a:ext uri="{FF2B5EF4-FFF2-40B4-BE49-F238E27FC236}">
                <a16:creationId xmlns:a16="http://schemas.microsoft.com/office/drawing/2014/main" xmlns="" id="{FE578D01-1749-FD45-A5C8-F17C141917E1}"/>
              </a:ext>
            </a:extLst>
          </p:cNvPr>
          <p:cNvSpPr txBox="1"/>
          <p:nvPr/>
        </p:nvSpPr>
        <p:spPr>
          <a:xfrm>
            <a:off x="1358940" y="2765749"/>
            <a:ext cx="57227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PEAK2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pic>
        <p:nvPicPr>
          <p:cNvPr id="22" name="图片 28">
            <a:extLst>
              <a:ext uri="{FF2B5EF4-FFF2-40B4-BE49-F238E27FC236}">
                <a16:creationId xmlns:a16="http://schemas.microsoft.com/office/drawing/2014/main" xmlns="" id="{BF7DB086-EBE4-344B-A99B-C5F07EF1F14F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1807" t="3119" r="1559" b="22129"/>
          <a:stretch/>
        </p:blipFill>
        <p:spPr>
          <a:xfrm>
            <a:off x="2024109" y="3364338"/>
            <a:ext cx="3710867" cy="60528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9">
            <a:extLst>
              <a:ext uri="{FF2B5EF4-FFF2-40B4-BE49-F238E27FC236}">
                <a16:creationId xmlns:a16="http://schemas.microsoft.com/office/drawing/2014/main" xmlns="" id="{A6A2B0B2-A58B-B44A-88CF-6D8C251CD2FE}"/>
              </a:ext>
            </a:extLst>
          </p:cNvPr>
          <p:cNvSpPr txBox="1"/>
          <p:nvPr/>
        </p:nvSpPr>
        <p:spPr>
          <a:xfrm>
            <a:off x="1414306" y="3487583"/>
            <a:ext cx="479298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non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Actin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cxnSp>
        <p:nvCxnSpPr>
          <p:cNvPr id="24" name="直线连接符 30">
            <a:extLst>
              <a:ext uri="{FF2B5EF4-FFF2-40B4-BE49-F238E27FC236}">
                <a16:creationId xmlns:a16="http://schemas.microsoft.com/office/drawing/2014/main" xmlns="" id="{92525714-7E9E-D749-A2CB-347912969EE7}"/>
              </a:ext>
            </a:extLst>
          </p:cNvPr>
          <p:cNvCxnSpPr>
            <a:cxnSpLocks/>
          </p:cNvCxnSpPr>
          <p:nvPr/>
        </p:nvCxnSpPr>
        <p:spPr>
          <a:xfrm>
            <a:off x="2458131" y="1561895"/>
            <a:ext cx="764555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25" name="文本框 2">
            <a:extLst>
              <a:ext uri="{FF2B5EF4-FFF2-40B4-BE49-F238E27FC236}">
                <a16:creationId xmlns:a16="http://schemas.microsoft.com/office/drawing/2014/main" xmlns="" id="{56217745-A734-D540-A6F7-30BF41EAB499}"/>
              </a:ext>
            </a:extLst>
          </p:cNvPr>
          <p:cNvSpPr txBox="1"/>
          <p:nvPr/>
        </p:nvSpPr>
        <p:spPr>
          <a:xfrm>
            <a:off x="2404786" y="1252635"/>
            <a:ext cx="826690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PEAK2</a:t>
            </a:r>
            <a:r>
              <a:rPr kumimoji="0" lang="en-US" altLang="zh-CN" i="0" u="none" strike="noStrike" cap="none" spc="0" normalizeH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 </a:t>
            </a:r>
            <a:r>
              <a:rPr lang="en-US" altLang="zh-CN" dirty="0">
                <a:latin typeface="Calibri" charset="0"/>
                <a:ea typeface="Calibri" charset="0"/>
                <a:cs typeface="Calibri" charset="0"/>
                <a:sym typeface="Helvetica Light"/>
              </a:rPr>
              <a:t>KO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sp>
        <p:nvSpPr>
          <p:cNvPr id="26" name="文本框 31">
            <a:extLst>
              <a:ext uri="{FF2B5EF4-FFF2-40B4-BE49-F238E27FC236}">
                <a16:creationId xmlns:a16="http://schemas.microsoft.com/office/drawing/2014/main" xmlns="" id="{DD2C8192-E81B-7843-A39E-81DA9B490BDF}"/>
              </a:ext>
            </a:extLst>
          </p:cNvPr>
          <p:cNvSpPr txBox="1"/>
          <p:nvPr/>
        </p:nvSpPr>
        <p:spPr>
          <a:xfrm>
            <a:off x="3328241" y="1252635"/>
            <a:ext cx="107164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PEAK1</a:t>
            </a:r>
            <a:r>
              <a:rPr kumimoji="0" lang="en-US" altLang="zh-CN" i="0" u="none" strike="noStrike" cap="none" spc="0" normalizeH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 </a:t>
            </a:r>
            <a:r>
              <a:rPr lang="en-US" altLang="zh-CN" dirty="0">
                <a:latin typeface="Calibri" charset="0"/>
                <a:ea typeface="Calibri" charset="0"/>
                <a:cs typeface="Calibri" charset="0"/>
                <a:sym typeface="Helvetica Light"/>
              </a:rPr>
              <a:t>KO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cxnSp>
        <p:nvCxnSpPr>
          <p:cNvPr id="27" name="直线连接符 32">
            <a:extLst>
              <a:ext uri="{FF2B5EF4-FFF2-40B4-BE49-F238E27FC236}">
                <a16:creationId xmlns:a16="http://schemas.microsoft.com/office/drawing/2014/main" xmlns="" id="{FEBABF02-5A30-394D-8E66-A5F93323A01D}"/>
              </a:ext>
            </a:extLst>
          </p:cNvPr>
          <p:cNvCxnSpPr>
            <a:cxnSpLocks/>
          </p:cNvCxnSpPr>
          <p:nvPr/>
        </p:nvCxnSpPr>
        <p:spPr>
          <a:xfrm>
            <a:off x="3287780" y="1561895"/>
            <a:ext cx="107964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cxnSp>
        <p:nvCxnSpPr>
          <p:cNvPr id="28" name="直线连接符 33">
            <a:extLst>
              <a:ext uri="{FF2B5EF4-FFF2-40B4-BE49-F238E27FC236}">
                <a16:creationId xmlns:a16="http://schemas.microsoft.com/office/drawing/2014/main" xmlns="" id="{E691335A-BF88-FF4C-A0D7-593647DE70E1}"/>
              </a:ext>
            </a:extLst>
          </p:cNvPr>
          <p:cNvCxnSpPr>
            <a:cxnSpLocks/>
          </p:cNvCxnSpPr>
          <p:nvPr/>
        </p:nvCxnSpPr>
        <p:spPr>
          <a:xfrm>
            <a:off x="4492602" y="1576774"/>
            <a:ext cx="1079649" cy="0"/>
          </a:xfrm>
          <a:prstGeom prst="line">
            <a:avLst/>
          </a:prstGeom>
          <a:noFill/>
          <a:ln w="12700" cap="flat">
            <a:solidFill>
              <a:srgbClr val="000000"/>
            </a:solidFill>
            <a:prstDash val="solid"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</p:cxnSp>
      <p:sp>
        <p:nvSpPr>
          <p:cNvPr id="29" name="文本框 34">
            <a:extLst>
              <a:ext uri="{FF2B5EF4-FFF2-40B4-BE49-F238E27FC236}">
                <a16:creationId xmlns:a16="http://schemas.microsoft.com/office/drawing/2014/main" xmlns="" id="{F51A609A-8E8D-0D41-A4CB-325C394D3F7D}"/>
              </a:ext>
            </a:extLst>
          </p:cNvPr>
          <p:cNvSpPr txBox="1"/>
          <p:nvPr/>
        </p:nvSpPr>
        <p:spPr>
          <a:xfrm>
            <a:off x="4668480" y="1249808"/>
            <a:ext cx="774463" cy="318036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marR="0" indent="0" algn="ctr" defTabSz="5842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r>
              <a:rPr kumimoji="0" lang="en-US" altLang="zh-CN" i="0" u="none" strike="noStrike" cap="none" spc="0" normalizeH="0" baseline="0" dirty="0">
                <a:ln>
                  <a:noFill/>
                </a:ln>
                <a:solidFill>
                  <a:srgbClr val="000000"/>
                </a:solidFill>
                <a:effectLst/>
                <a:uFillTx/>
                <a:latin typeface="Calibri" charset="0"/>
                <a:ea typeface="Calibri" charset="0"/>
                <a:cs typeface="Calibri" charset="0"/>
                <a:sym typeface="Helvetica Light"/>
              </a:rPr>
              <a:t>DKO</a:t>
            </a:r>
            <a:endParaRPr kumimoji="0" lang="zh-CN" altLang="en-US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Calibri" charset="0"/>
              <a:ea typeface="Calibri" charset="0"/>
              <a:cs typeface="Calibri" charset="0"/>
              <a:sym typeface="Helvetica Light"/>
            </a:endParaRPr>
          </a:p>
        </p:txBody>
      </p:sp>
      <p:pic>
        <p:nvPicPr>
          <p:cNvPr id="32" name="Picture 31"/>
          <p:cNvPicPr>
            <a:picLocks noChangeAspect="1"/>
          </p:cNvPicPr>
          <p:nvPr/>
        </p:nvPicPr>
        <p:blipFill rotWithShape="1">
          <a:blip r:embed="rId4"/>
          <a:srcRect b="8041"/>
          <a:stretch/>
        </p:blipFill>
        <p:spPr>
          <a:xfrm>
            <a:off x="2013231" y="2700584"/>
            <a:ext cx="3721100" cy="4788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3" name="文本框 11">
            <a:extLst>
              <a:ext uri="{FF2B5EF4-FFF2-40B4-BE49-F238E27FC236}">
                <a16:creationId xmlns:a16="http://schemas.microsoft.com/office/drawing/2014/main" xmlns="" id="{6A48ED96-1460-9A4E-8636-01D351A8D360}"/>
              </a:ext>
            </a:extLst>
          </p:cNvPr>
          <p:cNvSpPr txBox="1"/>
          <p:nvPr/>
        </p:nvSpPr>
        <p:spPr>
          <a:xfrm>
            <a:off x="1113394" y="1632442"/>
            <a:ext cx="9060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>
                <a:latin typeface="Calibri" panose="020F0502020204030204" pitchFamily="34" charset="0"/>
                <a:cs typeface="Calibri" panose="020F0502020204030204" pitchFamily="34" charset="0"/>
              </a:rPr>
              <a:t>MCF-10A:</a:t>
            </a:r>
            <a:endParaRPr kumimoji="1" lang="zh-CN" altLang="en-US" sz="14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0" name="矩形 3">
            <a:extLst>
              <a:ext uri="{FF2B5EF4-FFF2-40B4-BE49-F238E27FC236}">
                <a16:creationId xmlns:a16="http://schemas.microsoft.com/office/drawing/2014/main" xmlns="" id="{DDDC158D-88B1-CC48-AE8A-3B04F2773034}"/>
              </a:ext>
            </a:extLst>
          </p:cNvPr>
          <p:cNvSpPr/>
          <p:nvPr/>
        </p:nvSpPr>
        <p:spPr>
          <a:xfrm>
            <a:off x="660458" y="8258582"/>
            <a:ext cx="533556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zh-CN" sz="1000" dirty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Figure EV1</a:t>
            </a:r>
            <a:endParaRPr lang="zh-CN" altLang="en-US" sz="1000" dirty="0">
              <a:latin typeface="Arial" panose="020B0604020202020204" pitchFamily="34" charset="0"/>
              <a:ea typeface="Calibri" charset="0"/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636104" y="83754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A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36104" y="4683319"/>
            <a:ext cx="2680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Calibri" panose="020F0502020204030204" pitchFamily="34" charset="0"/>
                <a:cs typeface="Calibri" panose="020F0502020204030204" pitchFamily="34" charset="0"/>
              </a:rPr>
              <a:t>B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053662" y="4951653"/>
            <a:ext cx="2622792" cy="2376289"/>
          </a:xfrm>
          <a:prstGeom prst="rect">
            <a:avLst/>
          </a:prstGeom>
        </p:spPr>
      </p:pic>
      <p:pic>
        <p:nvPicPr>
          <p:cNvPr id="19" name="Picture 1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751466" y="4926278"/>
            <a:ext cx="2561919" cy="23492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974336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矩形 3">
            <a:extLst>
              <a:ext uri="{FF2B5EF4-FFF2-40B4-BE49-F238E27FC236}">
                <a16:creationId xmlns:a16="http://schemas.microsoft.com/office/drawing/2014/main" xmlns="" id="{DDDC158D-88B1-CC48-AE8A-3B04F2773034}"/>
              </a:ext>
            </a:extLst>
          </p:cNvPr>
          <p:cNvSpPr/>
          <p:nvPr/>
        </p:nvSpPr>
        <p:spPr>
          <a:xfrm>
            <a:off x="425381" y="7512905"/>
            <a:ext cx="533556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zh-CN" sz="1000" dirty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Figure EV</a:t>
            </a:r>
            <a:r>
              <a:rPr lang="en-AU" altLang="zh-CN" sz="1000" dirty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2</a:t>
            </a:r>
            <a:endParaRPr lang="zh-CN" altLang="en-US" sz="1000" dirty="0">
              <a:latin typeface="Arial" panose="020B0604020202020204" pitchFamily="34" charset="0"/>
              <a:ea typeface="Calibri" charset="0"/>
              <a:cs typeface="Arial" panose="020B0604020202020204" pitchFamily="34" charset="0"/>
            </a:endParaRPr>
          </a:p>
        </p:txBody>
      </p:sp>
      <p:pic>
        <p:nvPicPr>
          <p:cNvPr id="21" name="Picture 20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2702" y="3984136"/>
            <a:ext cx="4818490" cy="23558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98380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xmlns="" id="{0F3258B1-AC50-3648-A39A-CEC15932741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8325" y="3053568"/>
            <a:ext cx="5014956" cy="4237638"/>
          </a:xfrm>
          <a:prstGeom prst="rect">
            <a:avLst/>
          </a:prstGeom>
        </p:spPr>
      </p:pic>
      <p:sp>
        <p:nvSpPr>
          <p:cNvPr id="68" name="Oval 67">
            <a:extLst>
              <a:ext uri="{FF2B5EF4-FFF2-40B4-BE49-F238E27FC236}">
                <a16:creationId xmlns:a16="http://schemas.microsoft.com/office/drawing/2014/main" xmlns="" id="{143FC0BB-5324-D845-AD6D-E24FB077F9AC}"/>
              </a:ext>
            </a:extLst>
          </p:cNvPr>
          <p:cNvSpPr/>
          <p:nvPr/>
        </p:nvSpPr>
        <p:spPr>
          <a:xfrm>
            <a:off x="3647978" y="4956419"/>
            <a:ext cx="625658" cy="445321"/>
          </a:xfrm>
          <a:prstGeom prst="ellipse">
            <a:avLst/>
          </a:prstGeom>
          <a:solidFill>
            <a:schemeClr val="accent6">
              <a:lumMod val="40000"/>
              <a:lumOff val="60000"/>
              <a:alpha val="30000"/>
            </a:schemeClr>
          </a:solidFill>
          <a:ln w="9525">
            <a:solidFill>
              <a:schemeClr val="accent6">
                <a:lumMod val="60000"/>
                <a:lumOff val="4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 dirty="0"/>
          </a:p>
        </p:txBody>
      </p:sp>
      <p:sp>
        <p:nvSpPr>
          <p:cNvPr id="93" name="Freeform 92">
            <a:extLst>
              <a:ext uri="{FF2B5EF4-FFF2-40B4-BE49-F238E27FC236}">
                <a16:creationId xmlns:a16="http://schemas.microsoft.com/office/drawing/2014/main" xmlns="" id="{A54C76FA-E086-5247-86A5-1FA51B699CA6}"/>
              </a:ext>
            </a:extLst>
          </p:cNvPr>
          <p:cNvSpPr/>
          <p:nvPr/>
        </p:nvSpPr>
        <p:spPr>
          <a:xfrm flipH="1">
            <a:off x="3281430" y="1196732"/>
            <a:ext cx="290643" cy="3948249"/>
          </a:xfrm>
          <a:custGeom>
            <a:avLst/>
            <a:gdLst>
              <a:gd name="connsiteX0" fmla="*/ 248194 w 261257"/>
              <a:gd name="connsiteY0" fmla="*/ 0 h 4859383"/>
              <a:gd name="connsiteX1" fmla="*/ 222068 w 261257"/>
              <a:gd name="connsiteY1" fmla="*/ 65315 h 4859383"/>
              <a:gd name="connsiteX2" fmla="*/ 195942 w 261257"/>
              <a:gd name="connsiteY2" fmla="*/ 104503 h 4859383"/>
              <a:gd name="connsiteX3" fmla="*/ 156754 w 261257"/>
              <a:gd name="connsiteY3" fmla="*/ 182880 h 4859383"/>
              <a:gd name="connsiteX4" fmla="*/ 117565 w 261257"/>
              <a:gd name="connsiteY4" fmla="*/ 261257 h 4859383"/>
              <a:gd name="connsiteX5" fmla="*/ 104502 w 261257"/>
              <a:gd name="connsiteY5" fmla="*/ 300446 h 4859383"/>
              <a:gd name="connsiteX6" fmla="*/ 65314 w 261257"/>
              <a:gd name="connsiteY6" fmla="*/ 496389 h 4859383"/>
              <a:gd name="connsiteX7" fmla="*/ 78377 w 261257"/>
              <a:gd name="connsiteY7" fmla="*/ 705395 h 4859383"/>
              <a:gd name="connsiteX8" fmla="*/ 91440 w 261257"/>
              <a:gd name="connsiteY8" fmla="*/ 757646 h 4859383"/>
              <a:gd name="connsiteX9" fmla="*/ 117565 w 261257"/>
              <a:gd name="connsiteY9" fmla="*/ 875212 h 4859383"/>
              <a:gd name="connsiteX10" fmla="*/ 169817 w 261257"/>
              <a:gd name="connsiteY10" fmla="*/ 953589 h 4859383"/>
              <a:gd name="connsiteX11" fmla="*/ 195942 w 261257"/>
              <a:gd name="connsiteY11" fmla="*/ 1031966 h 4859383"/>
              <a:gd name="connsiteX12" fmla="*/ 222068 w 261257"/>
              <a:gd name="connsiteY12" fmla="*/ 1071155 h 4859383"/>
              <a:gd name="connsiteX13" fmla="*/ 248194 w 261257"/>
              <a:gd name="connsiteY13" fmla="*/ 1149532 h 4859383"/>
              <a:gd name="connsiteX14" fmla="*/ 222068 w 261257"/>
              <a:gd name="connsiteY14" fmla="*/ 1319349 h 4859383"/>
              <a:gd name="connsiteX15" fmla="*/ 209005 w 261257"/>
              <a:gd name="connsiteY15" fmla="*/ 1358537 h 4859383"/>
              <a:gd name="connsiteX16" fmla="*/ 195942 w 261257"/>
              <a:gd name="connsiteY16" fmla="*/ 1423852 h 4859383"/>
              <a:gd name="connsiteX17" fmla="*/ 222068 w 261257"/>
              <a:gd name="connsiteY17" fmla="*/ 1685109 h 4859383"/>
              <a:gd name="connsiteX18" fmla="*/ 248194 w 261257"/>
              <a:gd name="connsiteY18" fmla="*/ 1763486 h 4859383"/>
              <a:gd name="connsiteX19" fmla="*/ 261257 w 261257"/>
              <a:gd name="connsiteY19" fmla="*/ 1802675 h 4859383"/>
              <a:gd name="connsiteX20" fmla="*/ 235131 w 261257"/>
              <a:gd name="connsiteY20" fmla="*/ 2050869 h 4859383"/>
              <a:gd name="connsiteX21" fmla="*/ 222068 w 261257"/>
              <a:gd name="connsiteY21" fmla="*/ 2155372 h 4859383"/>
              <a:gd name="connsiteX22" fmla="*/ 195942 w 261257"/>
              <a:gd name="connsiteY22" fmla="*/ 2259875 h 4859383"/>
              <a:gd name="connsiteX23" fmla="*/ 169817 w 261257"/>
              <a:gd name="connsiteY23" fmla="*/ 2351315 h 4859383"/>
              <a:gd name="connsiteX24" fmla="*/ 156754 w 261257"/>
              <a:gd name="connsiteY24" fmla="*/ 2403566 h 4859383"/>
              <a:gd name="connsiteX25" fmla="*/ 130628 w 261257"/>
              <a:gd name="connsiteY25" fmla="*/ 2481943 h 4859383"/>
              <a:gd name="connsiteX26" fmla="*/ 143691 w 261257"/>
              <a:gd name="connsiteY26" fmla="*/ 2586446 h 4859383"/>
              <a:gd name="connsiteX27" fmla="*/ 182880 w 261257"/>
              <a:gd name="connsiteY27" fmla="*/ 2677886 h 4859383"/>
              <a:gd name="connsiteX28" fmla="*/ 209005 w 261257"/>
              <a:gd name="connsiteY28" fmla="*/ 2717075 h 4859383"/>
              <a:gd name="connsiteX29" fmla="*/ 235131 w 261257"/>
              <a:gd name="connsiteY29" fmla="*/ 2795452 h 4859383"/>
              <a:gd name="connsiteX30" fmla="*/ 248194 w 261257"/>
              <a:gd name="connsiteY30" fmla="*/ 2965269 h 4859383"/>
              <a:gd name="connsiteX31" fmla="*/ 235131 w 261257"/>
              <a:gd name="connsiteY31" fmla="*/ 3200400 h 4859383"/>
              <a:gd name="connsiteX32" fmla="*/ 209005 w 261257"/>
              <a:gd name="connsiteY32" fmla="*/ 3278777 h 4859383"/>
              <a:gd name="connsiteX33" fmla="*/ 143691 w 261257"/>
              <a:gd name="connsiteY33" fmla="*/ 3396343 h 4859383"/>
              <a:gd name="connsiteX34" fmla="*/ 65314 w 261257"/>
              <a:gd name="connsiteY34" fmla="*/ 3500846 h 4859383"/>
              <a:gd name="connsiteX35" fmla="*/ 39188 w 261257"/>
              <a:gd name="connsiteY35" fmla="*/ 3579223 h 4859383"/>
              <a:gd name="connsiteX36" fmla="*/ 26125 w 261257"/>
              <a:gd name="connsiteY36" fmla="*/ 3618412 h 4859383"/>
              <a:gd name="connsiteX37" fmla="*/ 0 w 261257"/>
              <a:gd name="connsiteY37" fmla="*/ 3670663 h 4859383"/>
              <a:gd name="connsiteX38" fmla="*/ 13062 w 261257"/>
              <a:gd name="connsiteY38" fmla="*/ 3958046 h 4859383"/>
              <a:gd name="connsiteX39" fmla="*/ 26125 w 261257"/>
              <a:gd name="connsiteY39" fmla="*/ 3997235 h 4859383"/>
              <a:gd name="connsiteX40" fmla="*/ 39188 w 261257"/>
              <a:gd name="connsiteY40" fmla="*/ 4049486 h 4859383"/>
              <a:gd name="connsiteX41" fmla="*/ 52251 w 261257"/>
              <a:gd name="connsiteY41" fmla="*/ 4127863 h 4859383"/>
              <a:gd name="connsiteX42" fmla="*/ 65314 w 261257"/>
              <a:gd name="connsiteY42" fmla="*/ 4167052 h 4859383"/>
              <a:gd name="connsiteX43" fmla="*/ 91440 w 261257"/>
              <a:gd name="connsiteY43" fmla="*/ 4271555 h 4859383"/>
              <a:gd name="connsiteX44" fmla="*/ 78377 w 261257"/>
              <a:gd name="connsiteY44" fmla="*/ 4441372 h 4859383"/>
              <a:gd name="connsiteX45" fmla="*/ 65314 w 261257"/>
              <a:gd name="connsiteY45" fmla="*/ 4532812 h 4859383"/>
              <a:gd name="connsiteX46" fmla="*/ 52251 w 261257"/>
              <a:gd name="connsiteY46" fmla="*/ 4650377 h 4859383"/>
              <a:gd name="connsiteX47" fmla="*/ 91440 w 261257"/>
              <a:gd name="connsiteY47" fmla="*/ 4807132 h 4859383"/>
              <a:gd name="connsiteX48" fmla="*/ 117565 w 261257"/>
              <a:gd name="connsiteY48" fmla="*/ 4859383 h 48593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</a:cxnLst>
            <a:rect l="l" t="t" r="r" b="b"/>
            <a:pathLst>
              <a:path w="261257" h="4859383">
                <a:moveTo>
                  <a:pt x="248194" y="0"/>
                </a:moveTo>
                <a:cubicBezTo>
                  <a:pt x="239485" y="21772"/>
                  <a:pt x="232555" y="44342"/>
                  <a:pt x="222068" y="65315"/>
                </a:cubicBezTo>
                <a:cubicBezTo>
                  <a:pt x="215047" y="79357"/>
                  <a:pt x="202963" y="90461"/>
                  <a:pt x="195942" y="104503"/>
                </a:cubicBezTo>
                <a:cubicBezTo>
                  <a:pt x="141860" y="212668"/>
                  <a:pt x="231627" y="70573"/>
                  <a:pt x="156754" y="182880"/>
                </a:cubicBezTo>
                <a:cubicBezTo>
                  <a:pt x="123920" y="281383"/>
                  <a:pt x="168211" y="159966"/>
                  <a:pt x="117565" y="261257"/>
                </a:cubicBezTo>
                <a:cubicBezTo>
                  <a:pt x="111407" y="273573"/>
                  <a:pt x="108125" y="287162"/>
                  <a:pt x="104502" y="300446"/>
                </a:cubicBezTo>
                <a:cubicBezTo>
                  <a:pt x="74270" y="411301"/>
                  <a:pt x="80574" y="389571"/>
                  <a:pt x="65314" y="496389"/>
                </a:cubicBezTo>
                <a:cubicBezTo>
                  <a:pt x="69668" y="566058"/>
                  <a:pt x="71431" y="635937"/>
                  <a:pt x="78377" y="705395"/>
                </a:cubicBezTo>
                <a:cubicBezTo>
                  <a:pt x="80163" y="723259"/>
                  <a:pt x="87919" y="740042"/>
                  <a:pt x="91440" y="757646"/>
                </a:cubicBezTo>
                <a:cubicBezTo>
                  <a:pt x="96092" y="780908"/>
                  <a:pt x="101675" y="846611"/>
                  <a:pt x="117565" y="875212"/>
                </a:cubicBezTo>
                <a:cubicBezTo>
                  <a:pt x="132814" y="902660"/>
                  <a:pt x="159888" y="923801"/>
                  <a:pt x="169817" y="953589"/>
                </a:cubicBezTo>
                <a:cubicBezTo>
                  <a:pt x="178525" y="979715"/>
                  <a:pt x="180666" y="1009052"/>
                  <a:pt x="195942" y="1031966"/>
                </a:cubicBezTo>
                <a:cubicBezTo>
                  <a:pt x="204651" y="1045029"/>
                  <a:pt x="215692" y="1056808"/>
                  <a:pt x="222068" y="1071155"/>
                </a:cubicBezTo>
                <a:cubicBezTo>
                  <a:pt x="233253" y="1096320"/>
                  <a:pt x="248194" y="1149532"/>
                  <a:pt x="248194" y="1149532"/>
                </a:cubicBezTo>
                <a:cubicBezTo>
                  <a:pt x="240262" y="1212986"/>
                  <a:pt x="237029" y="1259507"/>
                  <a:pt x="222068" y="1319349"/>
                </a:cubicBezTo>
                <a:cubicBezTo>
                  <a:pt x="218728" y="1332707"/>
                  <a:pt x="212345" y="1345179"/>
                  <a:pt x="209005" y="1358537"/>
                </a:cubicBezTo>
                <a:cubicBezTo>
                  <a:pt x="203620" y="1380077"/>
                  <a:pt x="200296" y="1402080"/>
                  <a:pt x="195942" y="1423852"/>
                </a:cubicBezTo>
                <a:cubicBezTo>
                  <a:pt x="203987" y="1552569"/>
                  <a:pt x="193654" y="1590395"/>
                  <a:pt x="222068" y="1685109"/>
                </a:cubicBezTo>
                <a:cubicBezTo>
                  <a:pt x="229981" y="1711486"/>
                  <a:pt x="239485" y="1737360"/>
                  <a:pt x="248194" y="1763486"/>
                </a:cubicBezTo>
                <a:lnTo>
                  <a:pt x="261257" y="1802675"/>
                </a:lnTo>
                <a:cubicBezTo>
                  <a:pt x="238161" y="2102915"/>
                  <a:pt x="261260" y="1867966"/>
                  <a:pt x="235131" y="2050869"/>
                </a:cubicBezTo>
                <a:cubicBezTo>
                  <a:pt x="230166" y="2085622"/>
                  <a:pt x="228538" y="2120868"/>
                  <a:pt x="222068" y="2155372"/>
                </a:cubicBezTo>
                <a:cubicBezTo>
                  <a:pt x="215451" y="2190663"/>
                  <a:pt x="204650" y="2225041"/>
                  <a:pt x="195942" y="2259875"/>
                </a:cubicBezTo>
                <a:cubicBezTo>
                  <a:pt x="155107" y="2423216"/>
                  <a:pt x="207297" y="2220136"/>
                  <a:pt x="169817" y="2351315"/>
                </a:cubicBezTo>
                <a:cubicBezTo>
                  <a:pt x="164885" y="2368577"/>
                  <a:pt x="161913" y="2386370"/>
                  <a:pt x="156754" y="2403566"/>
                </a:cubicBezTo>
                <a:cubicBezTo>
                  <a:pt x="148841" y="2429943"/>
                  <a:pt x="130628" y="2481943"/>
                  <a:pt x="130628" y="2481943"/>
                </a:cubicBezTo>
                <a:cubicBezTo>
                  <a:pt x="134982" y="2516777"/>
                  <a:pt x="137411" y="2551907"/>
                  <a:pt x="143691" y="2586446"/>
                </a:cubicBezTo>
                <a:cubicBezTo>
                  <a:pt x="148576" y="2613315"/>
                  <a:pt x="170869" y="2656867"/>
                  <a:pt x="182880" y="2677886"/>
                </a:cubicBezTo>
                <a:cubicBezTo>
                  <a:pt x="190669" y="2691517"/>
                  <a:pt x="202629" y="2702729"/>
                  <a:pt x="209005" y="2717075"/>
                </a:cubicBezTo>
                <a:cubicBezTo>
                  <a:pt x="220190" y="2742240"/>
                  <a:pt x="235131" y="2795452"/>
                  <a:pt x="235131" y="2795452"/>
                </a:cubicBezTo>
                <a:cubicBezTo>
                  <a:pt x="239485" y="2852058"/>
                  <a:pt x="248194" y="2908496"/>
                  <a:pt x="248194" y="2965269"/>
                </a:cubicBezTo>
                <a:cubicBezTo>
                  <a:pt x="248194" y="3043767"/>
                  <a:pt x="244868" y="3122508"/>
                  <a:pt x="235131" y="3200400"/>
                </a:cubicBezTo>
                <a:cubicBezTo>
                  <a:pt x="231715" y="3227726"/>
                  <a:pt x="217714" y="3252651"/>
                  <a:pt x="209005" y="3278777"/>
                </a:cubicBezTo>
                <a:cubicBezTo>
                  <a:pt x="186012" y="3347754"/>
                  <a:pt x="203581" y="3306508"/>
                  <a:pt x="143691" y="3396343"/>
                </a:cubicBezTo>
                <a:cubicBezTo>
                  <a:pt x="102101" y="3458729"/>
                  <a:pt x="127371" y="3423275"/>
                  <a:pt x="65314" y="3500846"/>
                </a:cubicBezTo>
                <a:lnTo>
                  <a:pt x="39188" y="3579223"/>
                </a:lnTo>
                <a:cubicBezTo>
                  <a:pt x="34834" y="3592286"/>
                  <a:pt x="32283" y="3606096"/>
                  <a:pt x="26125" y="3618412"/>
                </a:cubicBezTo>
                <a:lnTo>
                  <a:pt x="0" y="3670663"/>
                </a:lnTo>
                <a:cubicBezTo>
                  <a:pt x="4354" y="3766457"/>
                  <a:pt x="5415" y="3862458"/>
                  <a:pt x="13062" y="3958046"/>
                </a:cubicBezTo>
                <a:cubicBezTo>
                  <a:pt x="14160" y="3971772"/>
                  <a:pt x="22342" y="3983995"/>
                  <a:pt x="26125" y="3997235"/>
                </a:cubicBezTo>
                <a:cubicBezTo>
                  <a:pt x="31057" y="4014497"/>
                  <a:pt x="35667" y="4031882"/>
                  <a:pt x="39188" y="4049486"/>
                </a:cubicBezTo>
                <a:cubicBezTo>
                  <a:pt x="44382" y="4075458"/>
                  <a:pt x="46505" y="4102008"/>
                  <a:pt x="52251" y="4127863"/>
                </a:cubicBezTo>
                <a:cubicBezTo>
                  <a:pt x="55238" y="4141305"/>
                  <a:pt x="61974" y="4153694"/>
                  <a:pt x="65314" y="4167052"/>
                </a:cubicBezTo>
                <a:lnTo>
                  <a:pt x="91440" y="4271555"/>
                </a:lnTo>
                <a:cubicBezTo>
                  <a:pt x="87086" y="4328161"/>
                  <a:pt x="84026" y="4384881"/>
                  <a:pt x="78377" y="4441372"/>
                </a:cubicBezTo>
                <a:cubicBezTo>
                  <a:pt x="75313" y="4472009"/>
                  <a:pt x="69133" y="4502260"/>
                  <a:pt x="65314" y="4532812"/>
                </a:cubicBezTo>
                <a:cubicBezTo>
                  <a:pt x="60423" y="4571937"/>
                  <a:pt x="56605" y="4611189"/>
                  <a:pt x="52251" y="4650377"/>
                </a:cubicBezTo>
                <a:cubicBezTo>
                  <a:pt x="69842" y="4755923"/>
                  <a:pt x="56937" y="4703623"/>
                  <a:pt x="91440" y="4807132"/>
                </a:cubicBezTo>
                <a:cubicBezTo>
                  <a:pt x="106450" y="4852163"/>
                  <a:pt x="94765" y="4836583"/>
                  <a:pt x="117565" y="4859383"/>
                </a:cubicBezTo>
              </a:path>
            </a:pathLst>
          </a:custGeom>
          <a:noFill/>
          <a:ln w="2222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xmlns="" id="{11AF1AFB-5F0D-DA44-B8D4-0B325451FEE3}"/>
              </a:ext>
            </a:extLst>
          </p:cNvPr>
          <p:cNvSpPr/>
          <p:nvPr/>
        </p:nvSpPr>
        <p:spPr>
          <a:xfrm>
            <a:off x="2977396" y="6424138"/>
            <a:ext cx="420308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N1</a:t>
            </a:r>
            <a:endParaRPr lang="en-US" sz="975" dirty="0">
              <a:latin typeface="Helvetica"/>
              <a:cs typeface="Helvetica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xmlns="" id="{3F75A246-5BDA-8C44-9E18-C7A817F2AB5A}"/>
              </a:ext>
            </a:extLst>
          </p:cNvPr>
          <p:cNvSpPr/>
          <p:nvPr/>
        </p:nvSpPr>
        <p:spPr>
          <a:xfrm>
            <a:off x="4094437" y="5878995"/>
            <a:ext cx="324128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J</a:t>
            </a:r>
            <a:endParaRPr lang="en-US" sz="975" dirty="0">
              <a:latin typeface="Helvetica"/>
              <a:cs typeface="Helvetica"/>
            </a:endParaRP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xmlns="" id="{C73EEEC6-79BE-D74F-9E17-1CB9ADE67654}"/>
              </a:ext>
            </a:extLst>
          </p:cNvPr>
          <p:cNvSpPr/>
          <p:nvPr/>
        </p:nvSpPr>
        <p:spPr>
          <a:xfrm>
            <a:off x="3817467" y="6397297"/>
            <a:ext cx="344966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K</a:t>
            </a:r>
            <a:endParaRPr lang="en-US" sz="975" dirty="0">
              <a:latin typeface="Helvetica"/>
              <a:cs typeface="Helvetica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xmlns="" id="{CA7817BC-94E6-D94B-AA27-9A6DBBD7C1F5}"/>
              </a:ext>
            </a:extLst>
          </p:cNvPr>
          <p:cNvSpPr/>
          <p:nvPr/>
        </p:nvSpPr>
        <p:spPr>
          <a:xfrm>
            <a:off x="4030498" y="5546160"/>
            <a:ext cx="330540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L</a:t>
            </a:r>
            <a:endParaRPr lang="en-US" sz="975" dirty="0">
              <a:latin typeface="Helvetica"/>
              <a:cs typeface="Helvetica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xmlns="" id="{002A782E-C335-A34F-838E-D4FFF5AA20C7}"/>
              </a:ext>
            </a:extLst>
          </p:cNvPr>
          <p:cNvSpPr/>
          <p:nvPr/>
        </p:nvSpPr>
        <p:spPr>
          <a:xfrm>
            <a:off x="4596704" y="6090883"/>
            <a:ext cx="365806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M</a:t>
            </a:r>
            <a:endParaRPr lang="en-US" sz="975" dirty="0">
              <a:latin typeface="Helvetica"/>
              <a:cs typeface="Helvetica"/>
            </a:endParaRPr>
          </a:p>
        </p:txBody>
      </p:sp>
      <p:sp>
        <p:nvSpPr>
          <p:cNvPr id="25" name="Arc 24">
            <a:extLst>
              <a:ext uri="{FF2B5EF4-FFF2-40B4-BE49-F238E27FC236}">
                <a16:creationId xmlns:a16="http://schemas.microsoft.com/office/drawing/2014/main" xmlns="" id="{F440DAA8-5E45-5C40-90EC-9BAC0CFF0513}"/>
              </a:ext>
            </a:extLst>
          </p:cNvPr>
          <p:cNvSpPr/>
          <p:nvPr/>
        </p:nvSpPr>
        <p:spPr>
          <a:xfrm>
            <a:off x="4490406" y="4362343"/>
            <a:ext cx="1209351" cy="551029"/>
          </a:xfrm>
          <a:prstGeom prst="arc">
            <a:avLst>
              <a:gd name="adj1" fmla="val 18090688"/>
              <a:gd name="adj2" fmla="val 9623304"/>
            </a:avLst>
          </a:prstGeom>
          <a:ln w="2857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 dirty="0"/>
          </a:p>
        </p:txBody>
      </p:sp>
      <p:sp>
        <p:nvSpPr>
          <p:cNvPr id="26" name="Arc 25">
            <a:extLst>
              <a:ext uri="{FF2B5EF4-FFF2-40B4-BE49-F238E27FC236}">
                <a16:creationId xmlns:a16="http://schemas.microsoft.com/office/drawing/2014/main" xmlns="" id="{626A106B-E889-D446-A8A9-D46428DEBC00}"/>
              </a:ext>
            </a:extLst>
          </p:cNvPr>
          <p:cNvSpPr/>
          <p:nvPr/>
        </p:nvSpPr>
        <p:spPr>
          <a:xfrm>
            <a:off x="4844298" y="3920245"/>
            <a:ext cx="631296" cy="446256"/>
          </a:xfrm>
          <a:prstGeom prst="arc">
            <a:avLst>
              <a:gd name="adj1" fmla="val 19624541"/>
              <a:gd name="adj2" fmla="val 7069481"/>
            </a:avLst>
          </a:prstGeom>
          <a:ln w="28575">
            <a:solidFill>
              <a:srgbClr val="FF000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27" name="Arc 26">
            <a:extLst>
              <a:ext uri="{FF2B5EF4-FFF2-40B4-BE49-F238E27FC236}">
                <a16:creationId xmlns:a16="http://schemas.microsoft.com/office/drawing/2014/main" xmlns="" id="{6256FCA2-E84B-5845-8A24-2BC4AA508296}"/>
              </a:ext>
            </a:extLst>
          </p:cNvPr>
          <p:cNvSpPr/>
          <p:nvPr/>
        </p:nvSpPr>
        <p:spPr>
          <a:xfrm>
            <a:off x="4458864" y="4809738"/>
            <a:ext cx="1055665" cy="509405"/>
          </a:xfrm>
          <a:prstGeom prst="arc">
            <a:avLst>
              <a:gd name="adj1" fmla="val 15110509"/>
              <a:gd name="adj2" fmla="val 21509654"/>
            </a:avLst>
          </a:prstGeom>
          <a:ln w="2857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D3F30BEF-2D95-8A4C-842E-A3D03C445C64}"/>
              </a:ext>
            </a:extLst>
          </p:cNvPr>
          <p:cNvSpPr txBox="1"/>
          <p:nvPr/>
        </p:nvSpPr>
        <p:spPr>
          <a:xfrm>
            <a:off x="4021674" y="3578364"/>
            <a:ext cx="214681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 pitchFamily="2" charset="0"/>
                <a:cs typeface="Helvetica"/>
              </a:rPr>
              <a:t>SH3(2) motif </a:t>
            </a:r>
            <a:r>
              <a:rPr lang="en-AU" sz="975" dirty="0">
                <a:latin typeface="Helvetica" pitchFamily="2" charset="0"/>
              </a:rPr>
              <a:t>PGAPWR (PEAK3)</a:t>
            </a:r>
            <a:endParaRPr lang="en-US" sz="975" dirty="0">
              <a:latin typeface="Helvetica" pitchFamily="2" charset="0"/>
              <a:cs typeface="Helvetica"/>
            </a:endParaRPr>
          </a:p>
        </p:txBody>
      </p: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xmlns="" id="{9841890E-35A4-1946-8956-D2A01C5D4137}"/>
              </a:ext>
            </a:extLst>
          </p:cNvPr>
          <p:cNvCxnSpPr>
            <a:cxnSpLocks/>
            <a:endCxn id="121" idx="0"/>
          </p:cNvCxnSpPr>
          <p:nvPr/>
        </p:nvCxnSpPr>
        <p:spPr>
          <a:xfrm>
            <a:off x="5013906" y="3776334"/>
            <a:ext cx="41933" cy="503492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xmlns="" id="{C3894372-A9F0-C64C-BE8D-880462A3E7AE}"/>
              </a:ext>
            </a:extLst>
          </p:cNvPr>
          <p:cNvSpPr txBox="1"/>
          <p:nvPr/>
        </p:nvSpPr>
        <p:spPr>
          <a:xfrm>
            <a:off x="5699758" y="4346500"/>
            <a:ext cx="60646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N-lob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xmlns="" id="{31F73B5F-9E86-2449-9041-F1620E150329}"/>
              </a:ext>
            </a:extLst>
          </p:cNvPr>
          <p:cNvSpPr txBox="1"/>
          <p:nvPr/>
        </p:nvSpPr>
        <p:spPr>
          <a:xfrm>
            <a:off x="5699758" y="5452072"/>
            <a:ext cx="606467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C-lobe</a:t>
            </a:r>
          </a:p>
        </p:txBody>
      </p:sp>
      <p:sp>
        <p:nvSpPr>
          <p:cNvPr id="61" name="Arc 60">
            <a:extLst>
              <a:ext uri="{FF2B5EF4-FFF2-40B4-BE49-F238E27FC236}">
                <a16:creationId xmlns:a16="http://schemas.microsoft.com/office/drawing/2014/main" xmlns="" id="{A1CE068F-56CB-1E40-8371-3C47879675C5}"/>
              </a:ext>
            </a:extLst>
          </p:cNvPr>
          <p:cNvSpPr/>
          <p:nvPr/>
        </p:nvSpPr>
        <p:spPr>
          <a:xfrm flipH="1">
            <a:off x="3785482" y="4162800"/>
            <a:ext cx="462440" cy="732197"/>
          </a:xfrm>
          <a:prstGeom prst="arc">
            <a:avLst>
              <a:gd name="adj1" fmla="val 14217343"/>
              <a:gd name="adj2" fmla="val 4194407"/>
            </a:avLst>
          </a:prstGeom>
          <a:ln w="28575">
            <a:solidFill>
              <a:schemeClr val="bg1">
                <a:lumMod val="65000"/>
              </a:schemeClr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 dirty="0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xmlns="" id="{5EC02DE4-DAD0-E64C-9599-DCFF81BC18D3}"/>
              </a:ext>
            </a:extLst>
          </p:cNvPr>
          <p:cNvSpPr txBox="1"/>
          <p:nvPr/>
        </p:nvSpPr>
        <p:spPr>
          <a:xfrm>
            <a:off x="5435360" y="3930031"/>
            <a:ext cx="735843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Insertion loop</a:t>
            </a: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xmlns="" id="{DD326574-338C-DA41-929C-189AF7864452}"/>
              </a:ext>
            </a:extLst>
          </p:cNvPr>
          <p:cNvSpPr/>
          <p:nvPr/>
        </p:nvSpPr>
        <p:spPr>
          <a:xfrm>
            <a:off x="3500687" y="4818560"/>
            <a:ext cx="468398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F974</a:t>
            </a: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xmlns="" id="{CFAD3015-A9B5-D248-9AC7-DDA6F1D52D24}"/>
              </a:ext>
            </a:extLst>
          </p:cNvPr>
          <p:cNvSpPr/>
          <p:nvPr/>
        </p:nvSpPr>
        <p:spPr>
          <a:xfrm>
            <a:off x="3950793" y="5181591"/>
            <a:ext cx="579005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W1382</a:t>
            </a:r>
          </a:p>
        </p:txBody>
      </p:sp>
      <p:sp>
        <p:nvSpPr>
          <p:cNvPr id="67" name="Arc 66">
            <a:extLst>
              <a:ext uri="{FF2B5EF4-FFF2-40B4-BE49-F238E27FC236}">
                <a16:creationId xmlns:a16="http://schemas.microsoft.com/office/drawing/2014/main" xmlns="" id="{F310253C-A091-ED45-948A-1CA8EE878FCB}"/>
              </a:ext>
            </a:extLst>
          </p:cNvPr>
          <p:cNvSpPr/>
          <p:nvPr/>
        </p:nvSpPr>
        <p:spPr>
          <a:xfrm rot="18549686">
            <a:off x="3960310" y="6266190"/>
            <a:ext cx="182347" cy="399387"/>
          </a:xfrm>
          <a:prstGeom prst="arc">
            <a:avLst>
              <a:gd name="adj1" fmla="val 3437561"/>
              <a:gd name="adj2" fmla="val 9391925"/>
            </a:avLst>
          </a:prstGeom>
          <a:ln w="28575">
            <a:solidFill>
              <a:srgbClr val="002060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 dirty="0">
              <a:solidFill>
                <a:srgbClr val="002060"/>
              </a:solidFill>
              <a:highlight>
                <a:srgbClr val="000080"/>
              </a:highlight>
            </a:endParaRPr>
          </a:p>
        </p:txBody>
      </p:sp>
      <p:sp>
        <p:nvSpPr>
          <p:cNvPr id="92" name="Freeform 91">
            <a:extLst>
              <a:ext uri="{FF2B5EF4-FFF2-40B4-BE49-F238E27FC236}">
                <a16:creationId xmlns:a16="http://schemas.microsoft.com/office/drawing/2014/main" xmlns="" id="{53EC3861-5C97-C947-A092-754043608F08}"/>
              </a:ext>
            </a:extLst>
          </p:cNvPr>
          <p:cNvSpPr/>
          <p:nvPr/>
        </p:nvSpPr>
        <p:spPr>
          <a:xfrm>
            <a:off x="3045987" y="1241495"/>
            <a:ext cx="212271" cy="3948249"/>
          </a:xfrm>
          <a:custGeom>
            <a:avLst/>
            <a:gdLst>
              <a:gd name="connsiteX0" fmla="*/ 248194 w 261257"/>
              <a:gd name="connsiteY0" fmla="*/ 0 h 4859383"/>
              <a:gd name="connsiteX1" fmla="*/ 222068 w 261257"/>
              <a:gd name="connsiteY1" fmla="*/ 65315 h 4859383"/>
              <a:gd name="connsiteX2" fmla="*/ 195942 w 261257"/>
              <a:gd name="connsiteY2" fmla="*/ 104503 h 4859383"/>
              <a:gd name="connsiteX3" fmla="*/ 156754 w 261257"/>
              <a:gd name="connsiteY3" fmla="*/ 182880 h 4859383"/>
              <a:gd name="connsiteX4" fmla="*/ 117565 w 261257"/>
              <a:gd name="connsiteY4" fmla="*/ 261257 h 4859383"/>
              <a:gd name="connsiteX5" fmla="*/ 104502 w 261257"/>
              <a:gd name="connsiteY5" fmla="*/ 300446 h 4859383"/>
              <a:gd name="connsiteX6" fmla="*/ 65314 w 261257"/>
              <a:gd name="connsiteY6" fmla="*/ 496389 h 4859383"/>
              <a:gd name="connsiteX7" fmla="*/ 78377 w 261257"/>
              <a:gd name="connsiteY7" fmla="*/ 705395 h 4859383"/>
              <a:gd name="connsiteX8" fmla="*/ 91440 w 261257"/>
              <a:gd name="connsiteY8" fmla="*/ 757646 h 4859383"/>
              <a:gd name="connsiteX9" fmla="*/ 117565 w 261257"/>
              <a:gd name="connsiteY9" fmla="*/ 875212 h 4859383"/>
              <a:gd name="connsiteX10" fmla="*/ 169817 w 261257"/>
              <a:gd name="connsiteY10" fmla="*/ 953589 h 4859383"/>
              <a:gd name="connsiteX11" fmla="*/ 195942 w 261257"/>
              <a:gd name="connsiteY11" fmla="*/ 1031966 h 4859383"/>
              <a:gd name="connsiteX12" fmla="*/ 222068 w 261257"/>
              <a:gd name="connsiteY12" fmla="*/ 1071155 h 4859383"/>
              <a:gd name="connsiteX13" fmla="*/ 248194 w 261257"/>
              <a:gd name="connsiteY13" fmla="*/ 1149532 h 4859383"/>
              <a:gd name="connsiteX14" fmla="*/ 222068 w 261257"/>
              <a:gd name="connsiteY14" fmla="*/ 1319349 h 4859383"/>
              <a:gd name="connsiteX15" fmla="*/ 209005 w 261257"/>
              <a:gd name="connsiteY15" fmla="*/ 1358537 h 4859383"/>
              <a:gd name="connsiteX16" fmla="*/ 195942 w 261257"/>
              <a:gd name="connsiteY16" fmla="*/ 1423852 h 4859383"/>
              <a:gd name="connsiteX17" fmla="*/ 222068 w 261257"/>
              <a:gd name="connsiteY17" fmla="*/ 1685109 h 4859383"/>
              <a:gd name="connsiteX18" fmla="*/ 248194 w 261257"/>
              <a:gd name="connsiteY18" fmla="*/ 1763486 h 4859383"/>
              <a:gd name="connsiteX19" fmla="*/ 261257 w 261257"/>
              <a:gd name="connsiteY19" fmla="*/ 1802675 h 4859383"/>
              <a:gd name="connsiteX20" fmla="*/ 235131 w 261257"/>
              <a:gd name="connsiteY20" fmla="*/ 2050869 h 4859383"/>
              <a:gd name="connsiteX21" fmla="*/ 222068 w 261257"/>
              <a:gd name="connsiteY21" fmla="*/ 2155372 h 4859383"/>
              <a:gd name="connsiteX22" fmla="*/ 195942 w 261257"/>
              <a:gd name="connsiteY22" fmla="*/ 2259875 h 4859383"/>
              <a:gd name="connsiteX23" fmla="*/ 169817 w 261257"/>
              <a:gd name="connsiteY23" fmla="*/ 2351315 h 4859383"/>
              <a:gd name="connsiteX24" fmla="*/ 156754 w 261257"/>
              <a:gd name="connsiteY24" fmla="*/ 2403566 h 4859383"/>
              <a:gd name="connsiteX25" fmla="*/ 130628 w 261257"/>
              <a:gd name="connsiteY25" fmla="*/ 2481943 h 4859383"/>
              <a:gd name="connsiteX26" fmla="*/ 143691 w 261257"/>
              <a:gd name="connsiteY26" fmla="*/ 2586446 h 4859383"/>
              <a:gd name="connsiteX27" fmla="*/ 182880 w 261257"/>
              <a:gd name="connsiteY27" fmla="*/ 2677886 h 4859383"/>
              <a:gd name="connsiteX28" fmla="*/ 209005 w 261257"/>
              <a:gd name="connsiteY28" fmla="*/ 2717075 h 4859383"/>
              <a:gd name="connsiteX29" fmla="*/ 235131 w 261257"/>
              <a:gd name="connsiteY29" fmla="*/ 2795452 h 4859383"/>
              <a:gd name="connsiteX30" fmla="*/ 248194 w 261257"/>
              <a:gd name="connsiteY30" fmla="*/ 2965269 h 4859383"/>
              <a:gd name="connsiteX31" fmla="*/ 235131 w 261257"/>
              <a:gd name="connsiteY31" fmla="*/ 3200400 h 4859383"/>
              <a:gd name="connsiteX32" fmla="*/ 209005 w 261257"/>
              <a:gd name="connsiteY32" fmla="*/ 3278777 h 4859383"/>
              <a:gd name="connsiteX33" fmla="*/ 143691 w 261257"/>
              <a:gd name="connsiteY33" fmla="*/ 3396343 h 4859383"/>
              <a:gd name="connsiteX34" fmla="*/ 65314 w 261257"/>
              <a:gd name="connsiteY34" fmla="*/ 3500846 h 4859383"/>
              <a:gd name="connsiteX35" fmla="*/ 39188 w 261257"/>
              <a:gd name="connsiteY35" fmla="*/ 3579223 h 4859383"/>
              <a:gd name="connsiteX36" fmla="*/ 26125 w 261257"/>
              <a:gd name="connsiteY36" fmla="*/ 3618412 h 4859383"/>
              <a:gd name="connsiteX37" fmla="*/ 0 w 261257"/>
              <a:gd name="connsiteY37" fmla="*/ 3670663 h 4859383"/>
              <a:gd name="connsiteX38" fmla="*/ 13062 w 261257"/>
              <a:gd name="connsiteY38" fmla="*/ 3958046 h 4859383"/>
              <a:gd name="connsiteX39" fmla="*/ 26125 w 261257"/>
              <a:gd name="connsiteY39" fmla="*/ 3997235 h 4859383"/>
              <a:gd name="connsiteX40" fmla="*/ 39188 w 261257"/>
              <a:gd name="connsiteY40" fmla="*/ 4049486 h 4859383"/>
              <a:gd name="connsiteX41" fmla="*/ 52251 w 261257"/>
              <a:gd name="connsiteY41" fmla="*/ 4127863 h 4859383"/>
              <a:gd name="connsiteX42" fmla="*/ 65314 w 261257"/>
              <a:gd name="connsiteY42" fmla="*/ 4167052 h 4859383"/>
              <a:gd name="connsiteX43" fmla="*/ 91440 w 261257"/>
              <a:gd name="connsiteY43" fmla="*/ 4271555 h 4859383"/>
              <a:gd name="connsiteX44" fmla="*/ 78377 w 261257"/>
              <a:gd name="connsiteY44" fmla="*/ 4441372 h 4859383"/>
              <a:gd name="connsiteX45" fmla="*/ 65314 w 261257"/>
              <a:gd name="connsiteY45" fmla="*/ 4532812 h 4859383"/>
              <a:gd name="connsiteX46" fmla="*/ 52251 w 261257"/>
              <a:gd name="connsiteY46" fmla="*/ 4650377 h 4859383"/>
              <a:gd name="connsiteX47" fmla="*/ 91440 w 261257"/>
              <a:gd name="connsiteY47" fmla="*/ 4807132 h 4859383"/>
              <a:gd name="connsiteX48" fmla="*/ 117565 w 261257"/>
              <a:gd name="connsiteY48" fmla="*/ 4859383 h 485938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</a:cxnLst>
            <a:rect l="l" t="t" r="r" b="b"/>
            <a:pathLst>
              <a:path w="261257" h="4859383">
                <a:moveTo>
                  <a:pt x="248194" y="0"/>
                </a:moveTo>
                <a:cubicBezTo>
                  <a:pt x="239485" y="21772"/>
                  <a:pt x="232555" y="44342"/>
                  <a:pt x="222068" y="65315"/>
                </a:cubicBezTo>
                <a:cubicBezTo>
                  <a:pt x="215047" y="79357"/>
                  <a:pt x="202963" y="90461"/>
                  <a:pt x="195942" y="104503"/>
                </a:cubicBezTo>
                <a:cubicBezTo>
                  <a:pt x="141860" y="212668"/>
                  <a:pt x="231627" y="70573"/>
                  <a:pt x="156754" y="182880"/>
                </a:cubicBezTo>
                <a:cubicBezTo>
                  <a:pt x="123920" y="281383"/>
                  <a:pt x="168211" y="159966"/>
                  <a:pt x="117565" y="261257"/>
                </a:cubicBezTo>
                <a:cubicBezTo>
                  <a:pt x="111407" y="273573"/>
                  <a:pt x="108125" y="287162"/>
                  <a:pt x="104502" y="300446"/>
                </a:cubicBezTo>
                <a:cubicBezTo>
                  <a:pt x="74270" y="411301"/>
                  <a:pt x="80574" y="389571"/>
                  <a:pt x="65314" y="496389"/>
                </a:cubicBezTo>
                <a:cubicBezTo>
                  <a:pt x="69668" y="566058"/>
                  <a:pt x="71431" y="635937"/>
                  <a:pt x="78377" y="705395"/>
                </a:cubicBezTo>
                <a:cubicBezTo>
                  <a:pt x="80163" y="723259"/>
                  <a:pt x="87919" y="740042"/>
                  <a:pt x="91440" y="757646"/>
                </a:cubicBezTo>
                <a:cubicBezTo>
                  <a:pt x="96092" y="780908"/>
                  <a:pt x="101675" y="846611"/>
                  <a:pt x="117565" y="875212"/>
                </a:cubicBezTo>
                <a:cubicBezTo>
                  <a:pt x="132814" y="902660"/>
                  <a:pt x="159888" y="923801"/>
                  <a:pt x="169817" y="953589"/>
                </a:cubicBezTo>
                <a:cubicBezTo>
                  <a:pt x="178525" y="979715"/>
                  <a:pt x="180666" y="1009052"/>
                  <a:pt x="195942" y="1031966"/>
                </a:cubicBezTo>
                <a:cubicBezTo>
                  <a:pt x="204651" y="1045029"/>
                  <a:pt x="215692" y="1056808"/>
                  <a:pt x="222068" y="1071155"/>
                </a:cubicBezTo>
                <a:cubicBezTo>
                  <a:pt x="233253" y="1096320"/>
                  <a:pt x="248194" y="1149532"/>
                  <a:pt x="248194" y="1149532"/>
                </a:cubicBezTo>
                <a:cubicBezTo>
                  <a:pt x="240262" y="1212986"/>
                  <a:pt x="237029" y="1259507"/>
                  <a:pt x="222068" y="1319349"/>
                </a:cubicBezTo>
                <a:cubicBezTo>
                  <a:pt x="218728" y="1332707"/>
                  <a:pt x="212345" y="1345179"/>
                  <a:pt x="209005" y="1358537"/>
                </a:cubicBezTo>
                <a:cubicBezTo>
                  <a:pt x="203620" y="1380077"/>
                  <a:pt x="200296" y="1402080"/>
                  <a:pt x="195942" y="1423852"/>
                </a:cubicBezTo>
                <a:cubicBezTo>
                  <a:pt x="203987" y="1552569"/>
                  <a:pt x="193654" y="1590395"/>
                  <a:pt x="222068" y="1685109"/>
                </a:cubicBezTo>
                <a:cubicBezTo>
                  <a:pt x="229981" y="1711486"/>
                  <a:pt x="239485" y="1737360"/>
                  <a:pt x="248194" y="1763486"/>
                </a:cubicBezTo>
                <a:lnTo>
                  <a:pt x="261257" y="1802675"/>
                </a:lnTo>
                <a:cubicBezTo>
                  <a:pt x="238161" y="2102915"/>
                  <a:pt x="261260" y="1867966"/>
                  <a:pt x="235131" y="2050869"/>
                </a:cubicBezTo>
                <a:cubicBezTo>
                  <a:pt x="230166" y="2085622"/>
                  <a:pt x="228538" y="2120868"/>
                  <a:pt x="222068" y="2155372"/>
                </a:cubicBezTo>
                <a:cubicBezTo>
                  <a:pt x="215451" y="2190663"/>
                  <a:pt x="204650" y="2225041"/>
                  <a:pt x="195942" y="2259875"/>
                </a:cubicBezTo>
                <a:cubicBezTo>
                  <a:pt x="155107" y="2423216"/>
                  <a:pt x="207297" y="2220136"/>
                  <a:pt x="169817" y="2351315"/>
                </a:cubicBezTo>
                <a:cubicBezTo>
                  <a:pt x="164885" y="2368577"/>
                  <a:pt x="161913" y="2386370"/>
                  <a:pt x="156754" y="2403566"/>
                </a:cubicBezTo>
                <a:cubicBezTo>
                  <a:pt x="148841" y="2429943"/>
                  <a:pt x="130628" y="2481943"/>
                  <a:pt x="130628" y="2481943"/>
                </a:cubicBezTo>
                <a:cubicBezTo>
                  <a:pt x="134982" y="2516777"/>
                  <a:pt x="137411" y="2551907"/>
                  <a:pt x="143691" y="2586446"/>
                </a:cubicBezTo>
                <a:cubicBezTo>
                  <a:pt x="148576" y="2613315"/>
                  <a:pt x="170869" y="2656867"/>
                  <a:pt x="182880" y="2677886"/>
                </a:cubicBezTo>
                <a:cubicBezTo>
                  <a:pt x="190669" y="2691517"/>
                  <a:pt x="202629" y="2702729"/>
                  <a:pt x="209005" y="2717075"/>
                </a:cubicBezTo>
                <a:cubicBezTo>
                  <a:pt x="220190" y="2742240"/>
                  <a:pt x="235131" y="2795452"/>
                  <a:pt x="235131" y="2795452"/>
                </a:cubicBezTo>
                <a:cubicBezTo>
                  <a:pt x="239485" y="2852058"/>
                  <a:pt x="248194" y="2908496"/>
                  <a:pt x="248194" y="2965269"/>
                </a:cubicBezTo>
                <a:cubicBezTo>
                  <a:pt x="248194" y="3043767"/>
                  <a:pt x="244868" y="3122508"/>
                  <a:pt x="235131" y="3200400"/>
                </a:cubicBezTo>
                <a:cubicBezTo>
                  <a:pt x="231715" y="3227726"/>
                  <a:pt x="217714" y="3252651"/>
                  <a:pt x="209005" y="3278777"/>
                </a:cubicBezTo>
                <a:cubicBezTo>
                  <a:pt x="186012" y="3347754"/>
                  <a:pt x="203581" y="3306508"/>
                  <a:pt x="143691" y="3396343"/>
                </a:cubicBezTo>
                <a:cubicBezTo>
                  <a:pt x="102101" y="3458729"/>
                  <a:pt x="127371" y="3423275"/>
                  <a:pt x="65314" y="3500846"/>
                </a:cubicBezTo>
                <a:lnTo>
                  <a:pt x="39188" y="3579223"/>
                </a:lnTo>
                <a:cubicBezTo>
                  <a:pt x="34834" y="3592286"/>
                  <a:pt x="32283" y="3606096"/>
                  <a:pt x="26125" y="3618412"/>
                </a:cubicBezTo>
                <a:lnTo>
                  <a:pt x="0" y="3670663"/>
                </a:lnTo>
                <a:cubicBezTo>
                  <a:pt x="4354" y="3766457"/>
                  <a:pt x="5415" y="3862458"/>
                  <a:pt x="13062" y="3958046"/>
                </a:cubicBezTo>
                <a:cubicBezTo>
                  <a:pt x="14160" y="3971772"/>
                  <a:pt x="22342" y="3983995"/>
                  <a:pt x="26125" y="3997235"/>
                </a:cubicBezTo>
                <a:cubicBezTo>
                  <a:pt x="31057" y="4014497"/>
                  <a:pt x="35667" y="4031882"/>
                  <a:pt x="39188" y="4049486"/>
                </a:cubicBezTo>
                <a:cubicBezTo>
                  <a:pt x="44382" y="4075458"/>
                  <a:pt x="46505" y="4102008"/>
                  <a:pt x="52251" y="4127863"/>
                </a:cubicBezTo>
                <a:cubicBezTo>
                  <a:pt x="55238" y="4141305"/>
                  <a:pt x="61974" y="4153694"/>
                  <a:pt x="65314" y="4167052"/>
                </a:cubicBezTo>
                <a:lnTo>
                  <a:pt x="91440" y="4271555"/>
                </a:lnTo>
                <a:cubicBezTo>
                  <a:pt x="87086" y="4328161"/>
                  <a:pt x="84026" y="4384881"/>
                  <a:pt x="78377" y="4441372"/>
                </a:cubicBezTo>
                <a:cubicBezTo>
                  <a:pt x="75313" y="4472009"/>
                  <a:pt x="69133" y="4502260"/>
                  <a:pt x="65314" y="4532812"/>
                </a:cubicBezTo>
                <a:cubicBezTo>
                  <a:pt x="60423" y="4571937"/>
                  <a:pt x="56605" y="4611189"/>
                  <a:pt x="52251" y="4650377"/>
                </a:cubicBezTo>
                <a:cubicBezTo>
                  <a:pt x="69842" y="4755923"/>
                  <a:pt x="56937" y="4703623"/>
                  <a:pt x="91440" y="4807132"/>
                </a:cubicBezTo>
                <a:cubicBezTo>
                  <a:pt x="106450" y="4852163"/>
                  <a:pt x="94765" y="4836583"/>
                  <a:pt x="117565" y="4859383"/>
                </a:cubicBezTo>
              </a:path>
            </a:pathLst>
          </a:custGeom>
          <a:noFill/>
          <a:ln w="22225"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118" name="Oval 117">
            <a:extLst>
              <a:ext uri="{FF2B5EF4-FFF2-40B4-BE49-F238E27FC236}">
                <a16:creationId xmlns:a16="http://schemas.microsoft.com/office/drawing/2014/main" xmlns="" id="{0CA4D8A7-A843-B34C-9D0E-D96780BD1923}"/>
              </a:ext>
            </a:extLst>
          </p:cNvPr>
          <p:cNvSpPr/>
          <p:nvPr/>
        </p:nvSpPr>
        <p:spPr>
          <a:xfrm>
            <a:off x="3303050" y="3234358"/>
            <a:ext cx="150666" cy="146302"/>
          </a:xfrm>
          <a:prstGeom prst="ellipse">
            <a:avLst/>
          </a:prstGeom>
          <a:solidFill>
            <a:srgbClr val="FFB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xmlns="" id="{5D08DDA2-00E4-244D-9250-0B43B24F5F34}"/>
              </a:ext>
            </a:extLst>
          </p:cNvPr>
          <p:cNvSpPr txBox="1"/>
          <p:nvPr/>
        </p:nvSpPr>
        <p:spPr>
          <a:xfrm>
            <a:off x="3409042" y="3169462"/>
            <a:ext cx="1604865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75" dirty="0">
                <a:latin typeface="Helvetica" pitchFamily="2" charset="0"/>
              </a:rPr>
              <a:t>SH3(1) motif PPPLPKK </a:t>
            </a:r>
          </a:p>
        </p:txBody>
      </p:sp>
      <p:sp>
        <p:nvSpPr>
          <p:cNvPr id="119" name="Oval 118">
            <a:extLst>
              <a:ext uri="{FF2B5EF4-FFF2-40B4-BE49-F238E27FC236}">
                <a16:creationId xmlns:a16="http://schemas.microsoft.com/office/drawing/2014/main" xmlns="" id="{EC692459-0609-284E-BDB4-1B7B38B0E471}"/>
              </a:ext>
            </a:extLst>
          </p:cNvPr>
          <p:cNvSpPr/>
          <p:nvPr/>
        </p:nvSpPr>
        <p:spPr>
          <a:xfrm>
            <a:off x="3077369" y="3240119"/>
            <a:ext cx="150666" cy="146302"/>
          </a:xfrm>
          <a:prstGeom prst="ellipse">
            <a:avLst/>
          </a:prstGeom>
          <a:solidFill>
            <a:srgbClr val="FFB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xmlns="" id="{0AD9A13F-04D8-5F42-8376-9B2279BB44A9}"/>
              </a:ext>
            </a:extLst>
          </p:cNvPr>
          <p:cNvSpPr txBox="1"/>
          <p:nvPr/>
        </p:nvSpPr>
        <p:spPr>
          <a:xfrm>
            <a:off x="3388025" y="2523679"/>
            <a:ext cx="1395591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75" dirty="0">
                <a:latin typeface="Helvetica" pitchFamily="2" charset="0"/>
              </a:rPr>
              <a:t>SH2 motif </a:t>
            </a:r>
            <a:r>
              <a:rPr lang="en-AU" sz="975" dirty="0" smtClean="0">
                <a:latin typeface="Helvetica" pitchFamily="2" charset="0"/>
              </a:rPr>
              <a:t>YSNL</a:t>
            </a:r>
            <a:endParaRPr lang="en-US" sz="975" dirty="0">
              <a:latin typeface="Helvetica" pitchFamily="2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xmlns="" id="{FC32E754-9C97-B24B-8D63-DE9F877B00D5}"/>
              </a:ext>
            </a:extLst>
          </p:cNvPr>
          <p:cNvSpPr txBox="1"/>
          <p:nvPr/>
        </p:nvSpPr>
        <p:spPr>
          <a:xfrm>
            <a:off x="1474819" y="2485347"/>
            <a:ext cx="908661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sz="975" dirty="0">
                <a:latin typeface="Helvetica" pitchFamily="2" charset="0"/>
              </a:rPr>
              <a:t>Grb2 or </a:t>
            </a:r>
            <a:r>
              <a:rPr lang="en-AU" sz="975" dirty="0" err="1">
                <a:latin typeface="Helvetica" pitchFamily="2" charset="0"/>
              </a:rPr>
              <a:t>CrkII</a:t>
            </a:r>
            <a:r>
              <a:rPr lang="en-AU" sz="975" dirty="0">
                <a:latin typeface="Helvetica" pitchFamily="2" charset="0"/>
              </a:rPr>
              <a:t> </a:t>
            </a:r>
          </a:p>
          <a:p>
            <a:r>
              <a:rPr lang="en-AU" sz="975" dirty="0">
                <a:latin typeface="Helvetica" pitchFamily="2" charset="0"/>
              </a:rPr>
              <a:t>SH2 domain</a:t>
            </a:r>
            <a:endParaRPr lang="en-US" sz="975" dirty="0">
              <a:latin typeface="Helvetica" pitchFamily="2" charset="0"/>
            </a:endParaRPr>
          </a:p>
        </p:txBody>
      </p:sp>
      <p:sp>
        <p:nvSpPr>
          <p:cNvPr id="117" name="Oval 116">
            <a:extLst>
              <a:ext uri="{FF2B5EF4-FFF2-40B4-BE49-F238E27FC236}">
                <a16:creationId xmlns:a16="http://schemas.microsoft.com/office/drawing/2014/main" xmlns="" id="{E88376EF-84EA-D943-AAF9-71B34EDAEA1D}"/>
              </a:ext>
            </a:extLst>
          </p:cNvPr>
          <p:cNvSpPr/>
          <p:nvPr/>
        </p:nvSpPr>
        <p:spPr>
          <a:xfrm>
            <a:off x="3263996" y="2560678"/>
            <a:ext cx="189720" cy="196181"/>
          </a:xfrm>
          <a:prstGeom prst="ellipse">
            <a:avLst/>
          </a:prstGeom>
          <a:solidFill>
            <a:srgbClr val="F9E7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120" name="Oval 119">
            <a:extLst>
              <a:ext uri="{FF2B5EF4-FFF2-40B4-BE49-F238E27FC236}">
                <a16:creationId xmlns:a16="http://schemas.microsoft.com/office/drawing/2014/main" xmlns="" id="{4C56B701-9C04-EB4F-8EE9-9AD10E76A9BD}"/>
              </a:ext>
            </a:extLst>
          </p:cNvPr>
          <p:cNvSpPr/>
          <p:nvPr/>
        </p:nvSpPr>
        <p:spPr>
          <a:xfrm>
            <a:off x="3077357" y="2562936"/>
            <a:ext cx="189720" cy="196181"/>
          </a:xfrm>
          <a:prstGeom prst="ellipse">
            <a:avLst/>
          </a:prstGeom>
          <a:solidFill>
            <a:srgbClr val="F9E77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xmlns="" id="{6F08F885-4A05-354A-BAD8-7ED347363F1B}"/>
              </a:ext>
            </a:extLst>
          </p:cNvPr>
          <p:cNvSpPr/>
          <p:nvPr/>
        </p:nvSpPr>
        <p:spPr>
          <a:xfrm>
            <a:off x="3987403" y="4931092"/>
            <a:ext cx="537327" cy="24237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F1045</a:t>
            </a:r>
          </a:p>
        </p:txBody>
      </p:sp>
      <p:sp>
        <p:nvSpPr>
          <p:cNvPr id="121" name="Oval 120">
            <a:extLst>
              <a:ext uri="{FF2B5EF4-FFF2-40B4-BE49-F238E27FC236}">
                <a16:creationId xmlns:a16="http://schemas.microsoft.com/office/drawing/2014/main" xmlns="" id="{5AC7D530-58A7-E741-B93A-141BA354B5FD}"/>
              </a:ext>
            </a:extLst>
          </p:cNvPr>
          <p:cNvSpPr/>
          <p:nvPr/>
        </p:nvSpPr>
        <p:spPr>
          <a:xfrm>
            <a:off x="4980506" y="4279826"/>
            <a:ext cx="150666" cy="146302"/>
          </a:xfrm>
          <a:prstGeom prst="ellipse">
            <a:avLst/>
          </a:prstGeom>
          <a:solidFill>
            <a:srgbClr val="FFBF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135" name="Right Brace 134">
            <a:extLst>
              <a:ext uri="{FF2B5EF4-FFF2-40B4-BE49-F238E27FC236}">
                <a16:creationId xmlns:a16="http://schemas.microsoft.com/office/drawing/2014/main" xmlns="" id="{2C0B8D50-A855-6C47-BF90-B8A8A55CF84B}"/>
              </a:ext>
            </a:extLst>
          </p:cNvPr>
          <p:cNvSpPr/>
          <p:nvPr/>
        </p:nvSpPr>
        <p:spPr>
          <a:xfrm rot="5400000">
            <a:off x="3331623" y="5848679"/>
            <a:ext cx="262196" cy="1727463"/>
          </a:xfrm>
          <a:prstGeom prst="rightBrac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138"/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xmlns="" id="{AE194F3A-397E-E040-910A-1C34F125F78A}"/>
              </a:ext>
            </a:extLst>
          </p:cNvPr>
          <p:cNvSpPr txBox="1"/>
          <p:nvPr/>
        </p:nvSpPr>
        <p:spPr>
          <a:xfrm>
            <a:off x="2777917" y="6818939"/>
            <a:ext cx="1680948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 smtClean="0">
                <a:latin typeface="Helvetica"/>
                <a:cs typeface="Helvetica"/>
              </a:rPr>
              <a:t>Dimerization </a:t>
            </a:r>
            <a:r>
              <a:rPr lang="en-US" sz="975" dirty="0">
                <a:latin typeface="Helvetica"/>
                <a:cs typeface="Helvetica"/>
              </a:rPr>
              <a:t>interface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xmlns="" id="{78F11980-E4ED-B047-B3EF-2352254F43F0}"/>
              </a:ext>
            </a:extLst>
          </p:cNvPr>
          <p:cNvSpPr txBox="1"/>
          <p:nvPr/>
        </p:nvSpPr>
        <p:spPr>
          <a:xfrm>
            <a:off x="4662771" y="3905874"/>
            <a:ext cx="323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Symbol" pitchFamily="2" charset="2"/>
                <a:cs typeface="Helvetica"/>
              </a:rPr>
              <a:t>b</a:t>
            </a:r>
            <a:r>
              <a:rPr lang="en-US" sz="975" dirty="0">
                <a:latin typeface="Helvetica"/>
                <a:cs typeface="Helvetica"/>
              </a:rPr>
              <a:t>4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xmlns="" id="{9AD88195-81A1-724A-A87A-30840E698B69}"/>
              </a:ext>
            </a:extLst>
          </p:cNvPr>
          <p:cNvSpPr txBox="1"/>
          <p:nvPr/>
        </p:nvSpPr>
        <p:spPr>
          <a:xfrm>
            <a:off x="5127094" y="3928212"/>
            <a:ext cx="323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Symbol" pitchFamily="2" charset="2"/>
                <a:cs typeface="Helvetica"/>
              </a:rPr>
              <a:t>b</a:t>
            </a:r>
            <a:r>
              <a:rPr lang="en-US" sz="975" dirty="0">
                <a:latin typeface="Helvetica"/>
                <a:cs typeface="Helvetica"/>
              </a:rPr>
              <a:t>5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xmlns="" id="{9CAF75C0-BB34-3E45-A2F8-FDBFEC28C8FC}"/>
              </a:ext>
            </a:extLst>
          </p:cNvPr>
          <p:cNvSpPr txBox="1"/>
          <p:nvPr/>
        </p:nvSpPr>
        <p:spPr>
          <a:xfrm>
            <a:off x="4062172" y="4394150"/>
            <a:ext cx="323766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Symbol" pitchFamily="2" charset="2"/>
                <a:cs typeface="Helvetica"/>
              </a:rPr>
              <a:t>b</a:t>
            </a:r>
            <a:r>
              <a:rPr lang="en-US" sz="975" dirty="0">
                <a:latin typeface="Helvetica"/>
                <a:cs typeface="Helvetica"/>
              </a:rPr>
              <a:t>3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2431DCF4-30A6-A049-B1C2-8B6298DEB85E}"/>
              </a:ext>
            </a:extLst>
          </p:cNvPr>
          <p:cNvSpPr txBox="1"/>
          <p:nvPr/>
        </p:nvSpPr>
        <p:spPr>
          <a:xfrm>
            <a:off x="5013905" y="4108011"/>
            <a:ext cx="500624" cy="3924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ea typeface="Lucida Grande"/>
                <a:cs typeface="Helvetica"/>
              </a:rPr>
              <a:t>α-turn</a:t>
            </a:r>
            <a:endParaRPr lang="en-US" sz="975" dirty="0">
              <a:latin typeface="Helvetica"/>
              <a:cs typeface="Helvetica"/>
            </a:endParaRPr>
          </a:p>
        </p:txBody>
      </p:sp>
      <p:pic>
        <p:nvPicPr>
          <p:cNvPr id="50" name="Picture 49">
            <a:extLst>
              <a:ext uri="{FF2B5EF4-FFF2-40B4-BE49-F238E27FC236}">
                <a16:creationId xmlns:a16="http://schemas.microsoft.com/office/drawing/2014/main" xmlns="" id="{A281AD0A-8A00-924E-80BA-FEB6B7C7CBD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534" t="17782" r="22683" b="12343"/>
          <a:stretch/>
        </p:blipFill>
        <p:spPr>
          <a:xfrm>
            <a:off x="2328225" y="2454000"/>
            <a:ext cx="459450" cy="445911"/>
          </a:xfrm>
          <a:prstGeom prst="rect">
            <a:avLst/>
          </a:prstGeom>
        </p:spPr>
      </p:pic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0C217DAF-BE0E-1B48-95D7-9F5AEFEB7EDA}"/>
              </a:ext>
            </a:extLst>
          </p:cNvPr>
          <p:cNvSpPr txBox="1"/>
          <p:nvPr/>
        </p:nvSpPr>
        <p:spPr>
          <a:xfrm>
            <a:off x="1618523" y="3151705"/>
            <a:ext cx="869149" cy="3924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75" dirty="0" err="1">
                <a:latin typeface="Helvetica"/>
                <a:cs typeface="Helvetica"/>
              </a:rPr>
              <a:t>CrkII</a:t>
            </a:r>
            <a:endParaRPr lang="en-US" sz="975" dirty="0">
              <a:latin typeface="Helvetica"/>
              <a:cs typeface="Helvetica"/>
            </a:endParaRPr>
          </a:p>
          <a:p>
            <a:pPr algn="ctr"/>
            <a:r>
              <a:rPr lang="en-US" sz="975" dirty="0">
                <a:latin typeface="Helvetica"/>
                <a:cs typeface="Helvetica"/>
              </a:rPr>
              <a:t>SH3 domain</a:t>
            </a:r>
          </a:p>
        </p:txBody>
      </p:sp>
      <p:pic>
        <p:nvPicPr>
          <p:cNvPr id="53" name="Picture 52">
            <a:extLst>
              <a:ext uri="{FF2B5EF4-FFF2-40B4-BE49-F238E27FC236}">
                <a16:creationId xmlns:a16="http://schemas.microsoft.com/office/drawing/2014/main" xmlns="" id="{7A007594-6E59-934D-B777-BDD729AD265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383480" y="3011480"/>
            <a:ext cx="587548" cy="569486"/>
          </a:xfrm>
          <a:prstGeom prst="rect">
            <a:avLst/>
          </a:prstGeom>
        </p:spPr>
      </p:pic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xmlns="" id="{E4BA4B66-D25B-544A-A35C-46773A4AE453}"/>
              </a:ext>
            </a:extLst>
          </p:cNvPr>
          <p:cNvCxnSpPr>
            <a:cxnSpLocks/>
          </p:cNvCxnSpPr>
          <p:nvPr/>
        </p:nvCxnSpPr>
        <p:spPr>
          <a:xfrm>
            <a:off x="2799844" y="2658767"/>
            <a:ext cx="220533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xmlns="" id="{95650CA6-6BED-8846-8C7E-E3AF9D52F242}"/>
              </a:ext>
            </a:extLst>
          </p:cNvPr>
          <p:cNvCxnSpPr>
            <a:cxnSpLocks/>
          </p:cNvCxnSpPr>
          <p:nvPr/>
        </p:nvCxnSpPr>
        <p:spPr>
          <a:xfrm>
            <a:off x="2823004" y="3307509"/>
            <a:ext cx="222414" cy="350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14CC2276-E6C2-D245-A3E7-BFA3873FD183}"/>
              </a:ext>
            </a:extLst>
          </p:cNvPr>
          <p:cNvSpPr txBox="1"/>
          <p:nvPr/>
        </p:nvSpPr>
        <p:spPr>
          <a:xfrm>
            <a:off x="4789442" y="6376888"/>
            <a:ext cx="1013838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Monomer 1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C4537350-7FD9-3840-81DA-FA2D980BB461}"/>
              </a:ext>
            </a:extLst>
          </p:cNvPr>
          <p:cNvSpPr txBox="1"/>
          <p:nvPr/>
        </p:nvSpPr>
        <p:spPr>
          <a:xfrm>
            <a:off x="1460614" y="6397296"/>
            <a:ext cx="1013838" cy="2423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75" dirty="0">
                <a:latin typeface="Helvetica"/>
                <a:cs typeface="Helvetica"/>
              </a:rPr>
              <a:t>Monomer 2</a:t>
            </a:r>
          </a:p>
        </p:txBody>
      </p:sp>
      <p:sp>
        <p:nvSpPr>
          <p:cNvPr id="54" name="矩形 3">
            <a:extLst>
              <a:ext uri="{FF2B5EF4-FFF2-40B4-BE49-F238E27FC236}">
                <a16:creationId xmlns:a16="http://schemas.microsoft.com/office/drawing/2014/main" xmlns="" id="{DDDC158D-88B1-CC48-AE8A-3B04F2773034}"/>
              </a:ext>
            </a:extLst>
          </p:cNvPr>
          <p:cNvSpPr/>
          <p:nvPr/>
        </p:nvSpPr>
        <p:spPr>
          <a:xfrm>
            <a:off x="352594" y="7941842"/>
            <a:ext cx="5335565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" altLang="zh-CN" sz="1000" dirty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Figure </a:t>
            </a:r>
            <a:r>
              <a:rPr lang="en" altLang="zh-CN" sz="1000" dirty="0" smtClean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EV</a:t>
            </a:r>
            <a:r>
              <a:rPr lang="en-AU" altLang="zh-CN" sz="1000" dirty="0">
                <a:latin typeface="Arial" panose="020B0604020202020204" pitchFamily="34" charset="0"/>
                <a:ea typeface="Calibri" charset="0"/>
                <a:cs typeface="Arial" panose="020B0604020202020204" pitchFamily="34" charset="0"/>
              </a:rPr>
              <a:t>3</a:t>
            </a:r>
            <a:endParaRPr lang="zh-CN" altLang="en-US" sz="1000" dirty="0">
              <a:latin typeface="Arial" panose="020B0604020202020204" pitchFamily="34" charset="0"/>
              <a:ea typeface="Calibri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044864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Google Shape;142;p5"/>
          <p:cNvSpPr txBox="1"/>
          <p:nvPr/>
        </p:nvSpPr>
        <p:spPr>
          <a:xfrm>
            <a:off x="247076" y="1488"/>
            <a:ext cx="277640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12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3" name="Google Shape;143;p5"/>
          <p:cNvSpPr txBox="1"/>
          <p:nvPr/>
        </p:nvSpPr>
        <p:spPr>
          <a:xfrm>
            <a:off x="262870" y="1600686"/>
            <a:ext cx="227504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1200" b="1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44" name="Google Shape;144;p5"/>
          <p:cNvSpPr/>
          <p:nvPr/>
        </p:nvSpPr>
        <p:spPr>
          <a:xfrm>
            <a:off x="247076" y="8796102"/>
            <a:ext cx="6098904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 algn="just"/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Figure EV4</a:t>
            </a:r>
            <a:endParaRPr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Google Shape;143;p5">
            <a:extLst>
              <a:ext uri="{FF2B5EF4-FFF2-40B4-BE49-F238E27FC236}">
                <a16:creationId xmlns:a16="http://schemas.microsoft.com/office/drawing/2014/main" xmlns="" id="{8FECBAA8-5CB2-0248-B8C6-20653636A681}"/>
              </a:ext>
            </a:extLst>
          </p:cNvPr>
          <p:cNvSpPr txBox="1"/>
          <p:nvPr/>
        </p:nvSpPr>
        <p:spPr>
          <a:xfrm>
            <a:off x="376622" y="5675551"/>
            <a:ext cx="27122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sz="1200" b="1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45163" y="1925222"/>
            <a:ext cx="1679906" cy="1829601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68362" y="1877722"/>
            <a:ext cx="1661622" cy="183785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4954" y="1925221"/>
            <a:ext cx="1633220" cy="1855543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421633" y="3831777"/>
            <a:ext cx="1725179" cy="1853286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74954" y="3818549"/>
            <a:ext cx="1764931" cy="184129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441988" y="3748582"/>
            <a:ext cx="1771090" cy="1903261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58233" y="167476"/>
            <a:ext cx="2287065" cy="1606264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153116" y="6495678"/>
            <a:ext cx="4064000" cy="16129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80880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37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72" name="Google Shape;372;p12"/>
          <p:cNvPicPr preferRelativeResize="0"/>
          <p:nvPr/>
        </p:nvPicPr>
        <p:blipFill rotWithShape="1">
          <a:blip r:embed="rId3">
            <a:alphaModFix/>
          </a:blip>
          <a:srcRect l="4541" t="21206" r="425" b="24139"/>
          <a:stretch/>
        </p:blipFill>
        <p:spPr>
          <a:xfrm>
            <a:off x="1917054" y="5038331"/>
            <a:ext cx="3344620" cy="408286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pic>
        <p:nvPicPr>
          <p:cNvPr id="373" name="Google Shape;373;p12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917053" y="4394440"/>
            <a:ext cx="3344620" cy="410307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74" name="Google Shape;374;p12"/>
          <p:cNvSpPr/>
          <p:nvPr/>
        </p:nvSpPr>
        <p:spPr>
          <a:xfrm rot="-5400000">
            <a:off x="2503999" y="3923406"/>
            <a:ext cx="518091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Vector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5" name="Google Shape;375;p12"/>
          <p:cNvSpPr/>
          <p:nvPr/>
        </p:nvSpPr>
        <p:spPr>
          <a:xfrm rot="-5400000">
            <a:off x="2784494" y="3944074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1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376" name="Google Shape;376;p12"/>
          <p:cNvCxnSpPr/>
          <p:nvPr/>
        </p:nvCxnSpPr>
        <p:spPr>
          <a:xfrm>
            <a:off x="2693014" y="3699134"/>
            <a:ext cx="1007999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77" name="Google Shape;377;p12"/>
          <p:cNvSpPr txBox="1"/>
          <p:nvPr/>
        </p:nvSpPr>
        <p:spPr>
          <a:xfrm>
            <a:off x="2692674" y="3446093"/>
            <a:ext cx="1157647" cy="27695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MDA-MB-231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8" name="Google Shape;378;p12"/>
          <p:cNvSpPr/>
          <p:nvPr/>
        </p:nvSpPr>
        <p:spPr>
          <a:xfrm rot="-5400000">
            <a:off x="1578963" y="3807132"/>
            <a:ext cx="998991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ositive control 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79" name="Google Shape;379;p12"/>
          <p:cNvSpPr/>
          <p:nvPr/>
        </p:nvSpPr>
        <p:spPr>
          <a:xfrm rot="-5400000">
            <a:off x="3109403" y="3936760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2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0" name="Google Shape;380;p12"/>
          <p:cNvSpPr/>
          <p:nvPr/>
        </p:nvSpPr>
        <p:spPr>
          <a:xfrm rot="-5400000">
            <a:off x="3405766" y="3933929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3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1" name="Google Shape;381;p12"/>
          <p:cNvSpPr/>
          <p:nvPr/>
        </p:nvSpPr>
        <p:spPr>
          <a:xfrm rot="-5400000">
            <a:off x="3808031" y="3933928"/>
            <a:ext cx="518091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Vector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2" name="Google Shape;382;p12"/>
          <p:cNvSpPr/>
          <p:nvPr/>
        </p:nvSpPr>
        <p:spPr>
          <a:xfrm rot="-5400000">
            <a:off x="4090956" y="3926480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1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383" name="Google Shape;383;p12"/>
          <p:cNvCxnSpPr/>
          <p:nvPr/>
        </p:nvCxnSpPr>
        <p:spPr>
          <a:xfrm>
            <a:off x="4093674" y="3696801"/>
            <a:ext cx="1007999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384" name="Google Shape;384;p12"/>
          <p:cNvSpPr txBox="1"/>
          <p:nvPr/>
        </p:nvSpPr>
        <p:spPr>
          <a:xfrm>
            <a:off x="4337024" y="3446093"/>
            <a:ext cx="521297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RH30</a:t>
            </a:r>
            <a:endParaRPr/>
          </a:p>
        </p:txBody>
      </p:sp>
      <p:sp>
        <p:nvSpPr>
          <p:cNvPr id="385" name="Google Shape;385;p12"/>
          <p:cNvSpPr/>
          <p:nvPr/>
        </p:nvSpPr>
        <p:spPr>
          <a:xfrm rot="-5400000">
            <a:off x="4403369" y="3933927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2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6" name="Google Shape;386;p12"/>
          <p:cNvSpPr/>
          <p:nvPr/>
        </p:nvSpPr>
        <p:spPr>
          <a:xfrm rot="-5400000">
            <a:off x="4734760" y="3944074"/>
            <a:ext cx="556563" cy="2308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900">
                <a:solidFill>
                  <a:srgbClr val="333333"/>
                </a:solidFill>
                <a:latin typeface="Arial"/>
                <a:ea typeface="Arial"/>
                <a:cs typeface="Arial"/>
                <a:sym typeface="Arial"/>
              </a:rPr>
              <a:t>gRNA3</a:t>
            </a:r>
            <a:endParaRPr sz="9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7" name="Google Shape;387;p12"/>
          <p:cNvSpPr txBox="1"/>
          <p:nvPr/>
        </p:nvSpPr>
        <p:spPr>
          <a:xfrm>
            <a:off x="1329969" y="4442581"/>
            <a:ext cx="59638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EAK3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88" name="Google Shape;388;p12"/>
          <p:cNvSpPr txBox="1"/>
          <p:nvPr/>
        </p:nvSpPr>
        <p:spPr>
          <a:xfrm>
            <a:off x="1917053" y="7084378"/>
            <a:ext cx="5164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ctin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89" name="Google Shape;389;p12"/>
          <p:cNvPicPr preferRelativeResize="0"/>
          <p:nvPr/>
        </p:nvPicPr>
        <p:blipFill rotWithShape="1">
          <a:blip r:embed="rId5">
            <a:alphaModFix/>
          </a:blip>
          <a:srcRect r="64578"/>
          <a:stretch/>
        </p:blipFill>
        <p:spPr>
          <a:xfrm>
            <a:off x="2548611" y="6569200"/>
            <a:ext cx="598243" cy="410821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91" name="Google Shape;391;p12"/>
          <p:cNvSpPr txBox="1"/>
          <p:nvPr/>
        </p:nvSpPr>
        <p:spPr>
          <a:xfrm>
            <a:off x="2591322" y="6041330"/>
            <a:ext cx="455574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172</a:t>
            </a:r>
            <a:endParaRPr sz="1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2" name="Google Shape;392;p12"/>
          <p:cNvSpPr txBox="1"/>
          <p:nvPr/>
        </p:nvSpPr>
        <p:spPr>
          <a:xfrm rot="5400000">
            <a:off x="2783383" y="6302825"/>
            <a:ext cx="330540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KD</a:t>
            </a:r>
            <a:endParaRPr sz="1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393" name="Google Shape;393;p12"/>
          <p:cNvPicPr preferRelativeResize="0"/>
          <p:nvPr/>
        </p:nvPicPr>
        <p:blipFill rotWithShape="1">
          <a:blip r:embed="rId6">
            <a:alphaModFix/>
          </a:blip>
          <a:srcRect l="6606" t="7375" r="63617" b="4868"/>
          <a:stretch/>
        </p:blipFill>
        <p:spPr>
          <a:xfrm>
            <a:off x="2548610" y="7054486"/>
            <a:ext cx="598243" cy="336785"/>
          </a:xfrm>
          <a:prstGeom prst="rect">
            <a:avLst/>
          </a:prstGeom>
          <a:noFill/>
          <a:ln w="9525" cap="flat" cmpd="sng">
            <a:solidFill>
              <a:schemeClr val="dk1"/>
            </a:solidFill>
            <a:prstDash val="solid"/>
            <a:round/>
            <a:headEnd type="none" w="sm" len="sm"/>
            <a:tailEnd type="none" w="sm" len="sm"/>
          </a:ln>
        </p:spPr>
      </p:pic>
      <p:sp>
        <p:nvSpPr>
          <p:cNvPr id="394" name="Google Shape;394;p12"/>
          <p:cNvSpPr txBox="1"/>
          <p:nvPr/>
        </p:nvSpPr>
        <p:spPr>
          <a:xfrm>
            <a:off x="1385183" y="5075822"/>
            <a:ext cx="51648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ctin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5" name="Google Shape;395;p12"/>
          <p:cNvSpPr txBox="1"/>
          <p:nvPr/>
        </p:nvSpPr>
        <p:spPr>
          <a:xfrm>
            <a:off x="1908294" y="6617878"/>
            <a:ext cx="596382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PEAK3</a:t>
            </a:r>
            <a:endParaRPr sz="12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396" name="Google Shape;396;p12"/>
          <p:cNvSpPr txBox="1"/>
          <p:nvPr/>
        </p:nvSpPr>
        <p:spPr>
          <a:xfrm rot="5400000">
            <a:off x="2488144" y="6295834"/>
            <a:ext cx="397866" cy="24622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0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OTP</a:t>
            </a:r>
            <a:endParaRPr sz="10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cxnSp>
        <p:nvCxnSpPr>
          <p:cNvPr id="402" name="Google Shape;402;p12"/>
          <p:cNvCxnSpPr/>
          <p:nvPr/>
        </p:nvCxnSpPr>
        <p:spPr>
          <a:xfrm>
            <a:off x="2630930" y="6260665"/>
            <a:ext cx="358515" cy="0"/>
          </a:xfrm>
          <a:prstGeom prst="straightConnector1">
            <a:avLst/>
          </a:prstGeom>
          <a:noFill/>
          <a:ln w="9525" cap="flat" cmpd="sng">
            <a:solidFill>
              <a:schemeClr val="dk1"/>
            </a:solidFill>
            <a:prstDash val="solid"/>
            <a:miter lim="800000"/>
            <a:headEnd type="none" w="sm" len="sm"/>
            <a:tailEnd type="none" w="sm" len="sm"/>
          </a:ln>
        </p:spPr>
      </p:cxnSp>
      <p:sp>
        <p:nvSpPr>
          <p:cNvPr id="407" name="Google Shape;407;p12"/>
          <p:cNvSpPr/>
          <p:nvPr/>
        </p:nvSpPr>
        <p:spPr>
          <a:xfrm>
            <a:off x="391701" y="7789139"/>
            <a:ext cx="6007787" cy="2461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r>
              <a:rPr lang="en-US" sz="1000" dirty="0">
                <a:solidFill>
                  <a:schemeClr val="dk1"/>
                </a:solidFill>
                <a:latin typeface="Arial" panose="020B0604020202020204" pitchFamily="34" charset="0"/>
                <a:ea typeface="Calibri"/>
                <a:cs typeface="Arial" panose="020B0604020202020204" pitchFamily="34" charset="0"/>
                <a:sym typeface="Calibri"/>
              </a:rPr>
              <a:t>Figure EV5</a:t>
            </a:r>
            <a:endParaRPr sz="1000" dirty="0">
              <a:solidFill>
                <a:schemeClr val="dk1"/>
              </a:solidFill>
              <a:latin typeface="Arial" panose="020B0604020202020204" pitchFamily="34" charset="0"/>
              <a:ea typeface="Calibri"/>
              <a:cs typeface="Arial" panose="020B0604020202020204" pitchFamily="34" charset="0"/>
              <a:sym typeface="Calibri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xmlns="" id="{383DA2F4-4E44-9047-A7A7-29E0B5EBD16D}"/>
              </a:ext>
            </a:extLst>
          </p:cNvPr>
          <p:cNvSpPr txBox="1"/>
          <p:nvPr/>
        </p:nvSpPr>
        <p:spPr>
          <a:xfrm>
            <a:off x="784566" y="3558301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B</a:t>
            </a:r>
            <a:endParaRPr kumimoji="1" lang="zh-CN" altLang="en-US" sz="1200" dirty="0"/>
          </a:p>
        </p:txBody>
      </p:sp>
      <p:sp>
        <p:nvSpPr>
          <p:cNvPr id="38" name="文本框 38">
            <a:extLst>
              <a:ext uri="{FF2B5EF4-FFF2-40B4-BE49-F238E27FC236}">
                <a16:creationId xmlns:a16="http://schemas.microsoft.com/office/drawing/2014/main" xmlns="" id="{38227C91-3E3B-4C48-BCB3-2CAA9350B1F8}"/>
              </a:ext>
            </a:extLst>
          </p:cNvPr>
          <p:cNvSpPr txBox="1"/>
          <p:nvPr/>
        </p:nvSpPr>
        <p:spPr>
          <a:xfrm>
            <a:off x="784566" y="621183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C</a:t>
            </a:r>
            <a:endParaRPr kumimoji="1" lang="zh-CN" altLang="en-US" sz="1200" dirty="0"/>
          </a:p>
        </p:txBody>
      </p:sp>
      <p:pic>
        <p:nvPicPr>
          <p:cNvPr id="67" name="Picture 66"/>
          <p:cNvPicPr>
            <a:picLocks noChangeAspect="1"/>
          </p:cNvPicPr>
          <p:nvPr/>
        </p:nvPicPr>
        <p:blipFill rotWithShape="1">
          <a:blip r:embed="rId7"/>
          <a:srcRect l="17410" t="61004" r="51001" b="29629"/>
          <a:stretch/>
        </p:blipFill>
        <p:spPr>
          <a:xfrm>
            <a:off x="2301425" y="1735688"/>
            <a:ext cx="555762" cy="2650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2" name="TextBox 71"/>
          <p:cNvSpPr txBox="1"/>
          <p:nvPr/>
        </p:nvSpPr>
        <p:spPr>
          <a:xfrm rot="18534447">
            <a:off x="2215727" y="1272193"/>
            <a:ext cx="659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dirty="0">
                <a:latin typeface="Calibri" charset="0"/>
                <a:ea typeface="Calibri" charset="0"/>
                <a:cs typeface="Calibri" charset="0"/>
              </a:rPr>
              <a:t>Vector</a:t>
            </a:r>
          </a:p>
        </p:txBody>
      </p:sp>
      <p:sp>
        <p:nvSpPr>
          <p:cNvPr id="74" name="TextBox 73"/>
          <p:cNvSpPr txBox="1"/>
          <p:nvPr/>
        </p:nvSpPr>
        <p:spPr>
          <a:xfrm rot="18595382">
            <a:off x="2324093" y="981288"/>
            <a:ext cx="1574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charset="0"/>
                <a:ea typeface="Calibri" charset="0"/>
                <a:cs typeface="Calibri" charset="0"/>
              </a:rPr>
              <a:t> non-tagged PEAK3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619964" y="1723347"/>
            <a:ext cx="69442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Calibri" panose="020F0502020204030204" pitchFamily="34" charset="0"/>
                <a:ea typeface="Calibri" charset="0"/>
                <a:cs typeface="Calibri" panose="020F0502020204030204" pitchFamily="34" charset="0"/>
              </a:rPr>
              <a:t>PEAK3 </a:t>
            </a:r>
          </a:p>
          <a:p>
            <a:endParaRPr lang="en-US" sz="1400" dirty="0">
              <a:latin typeface="Calibri" panose="020F0502020204030204" pitchFamily="34" charset="0"/>
              <a:ea typeface="Calibri" charset="0"/>
              <a:cs typeface="Calibri" panose="020F050202020403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700626" y="2054617"/>
            <a:ext cx="5613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Calibri" panose="020F0502020204030204" pitchFamily="34" charset="0"/>
                <a:cs typeface="Calibri" panose="020F0502020204030204" pitchFamily="34" charset="0"/>
              </a:rPr>
              <a:t>Actin</a:t>
            </a: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ED75266-E3C1-4144-BC88-7AAE5B33757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299803" y="2095397"/>
            <a:ext cx="557392" cy="27545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4" name="文本框 53">
            <a:extLst>
              <a:ext uri="{FF2B5EF4-FFF2-40B4-BE49-F238E27FC236}">
                <a16:creationId xmlns:a16="http://schemas.microsoft.com/office/drawing/2014/main" xmlns="" id="{868984EA-58F4-2B4F-BB29-9152FF6D1128}"/>
              </a:ext>
            </a:extLst>
          </p:cNvPr>
          <p:cNvSpPr txBox="1"/>
          <p:nvPr/>
        </p:nvSpPr>
        <p:spPr>
          <a:xfrm>
            <a:off x="784566" y="921164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dirty="0"/>
              <a:t>A</a:t>
            </a:r>
            <a:endParaRPr kumimoji="1" lang="zh-CN" altLang="en-US" sz="1200" dirty="0"/>
          </a:p>
        </p:txBody>
      </p:sp>
    </p:spTree>
    <p:extLst>
      <p:ext uri="{BB962C8B-B14F-4D97-AF65-F5344CB8AC3E}">
        <p14:creationId xmlns:p14="http://schemas.microsoft.com/office/powerpoint/2010/main" val="4611235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046</TotalTime>
  <Words>116</Words>
  <Application>Microsoft Macintosh PowerPoint</Application>
  <PresentationFormat>A4 Paper (210x297 mm)</PresentationFormat>
  <Paragraphs>76</Paragraphs>
  <Slides>5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2" baseType="lpstr">
      <vt:lpstr>Calibri</vt:lpstr>
      <vt:lpstr>Helvetica</vt:lpstr>
      <vt:lpstr>Helvetica Light</vt:lpstr>
      <vt:lpstr>Lucida Grande</vt:lpstr>
      <vt:lpstr>Symbol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mei Hou</dc:creator>
  <cp:lastModifiedBy>Microsoft account</cp:lastModifiedBy>
  <cp:revision>408</cp:revision>
  <dcterms:created xsi:type="dcterms:W3CDTF">2020-01-26T06:53:52Z</dcterms:created>
  <dcterms:modified xsi:type="dcterms:W3CDTF">2021-02-18T06:36:25Z</dcterms:modified>
</cp:coreProperties>
</file>